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4"/>
  </p:notesMasterIdLst>
  <p:sldIdLst>
    <p:sldId id="256" r:id="rId2"/>
    <p:sldId id="257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EBADA"/>
    <a:srgbClr val="8DD3C7"/>
    <a:srgbClr val="B3B3B3"/>
    <a:srgbClr val="E5C494"/>
    <a:srgbClr val="FFD92F"/>
    <a:srgbClr val="A6D854"/>
    <a:srgbClr val="E78AC3"/>
    <a:srgbClr val="8DA0CB"/>
    <a:srgbClr val="FC8D62"/>
    <a:srgbClr val="66C2A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1111" autoAdjust="0"/>
  </p:normalViewPr>
  <p:slideViewPr>
    <p:cSldViewPr snapToGrid="0">
      <p:cViewPr varScale="1">
        <p:scale>
          <a:sx n="52" d="100"/>
          <a:sy n="52" d="100"/>
        </p:scale>
        <p:origin x="2712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Héctor Cañeque Rufo" userId="6da3b7e2-2289-4c25-b14d-207ec07af19d" providerId="ADAL" clId="{BB2BB312-80ED-4364-8A09-0E6A01272F1B}"/>
    <pc:docChg chg="custSel modSld">
      <pc:chgData name="Héctor Cañeque Rufo" userId="6da3b7e2-2289-4c25-b14d-207ec07af19d" providerId="ADAL" clId="{BB2BB312-80ED-4364-8A09-0E6A01272F1B}" dt="2024-02-23T10:20:20.169" v="56" actId="14100"/>
      <pc:docMkLst>
        <pc:docMk/>
      </pc:docMkLst>
      <pc:sldChg chg="delSp modSp mod">
        <pc:chgData name="Héctor Cañeque Rufo" userId="6da3b7e2-2289-4c25-b14d-207ec07af19d" providerId="ADAL" clId="{BB2BB312-80ED-4364-8A09-0E6A01272F1B}" dt="2024-02-23T10:20:20.169" v="56" actId="14100"/>
        <pc:sldMkLst>
          <pc:docMk/>
          <pc:sldMk cId="142087482" sldId="256"/>
        </pc:sldMkLst>
        <pc:spChg chg="del">
          <ac:chgData name="Héctor Cañeque Rufo" userId="6da3b7e2-2289-4c25-b14d-207ec07af19d" providerId="ADAL" clId="{BB2BB312-80ED-4364-8A09-0E6A01272F1B}" dt="2024-02-23T10:18:01.362" v="1" actId="478"/>
          <ac:spMkLst>
            <pc:docMk/>
            <pc:sldMk cId="142087482" sldId="256"/>
            <ac:spMk id="47" creationId="{8D4F7BC0-53AB-5173-5E59-BCBE70E2DE44}"/>
          </ac:spMkLst>
        </pc:spChg>
        <pc:spChg chg="mod">
          <ac:chgData name="Héctor Cañeque Rufo" userId="6da3b7e2-2289-4c25-b14d-207ec07af19d" providerId="ADAL" clId="{BB2BB312-80ED-4364-8A09-0E6A01272F1B}" dt="2024-02-23T10:18:26.923" v="48" actId="1038"/>
          <ac:spMkLst>
            <pc:docMk/>
            <pc:sldMk cId="142087482" sldId="256"/>
            <ac:spMk id="48" creationId="{1D496425-76CA-2A19-2F33-A486884CB010}"/>
          </ac:spMkLst>
        </pc:spChg>
        <pc:grpChg chg="mod">
          <ac:chgData name="Héctor Cañeque Rufo" userId="6da3b7e2-2289-4c25-b14d-207ec07af19d" providerId="ADAL" clId="{BB2BB312-80ED-4364-8A09-0E6A01272F1B}" dt="2024-02-23T10:18:20.946" v="27" actId="12788"/>
          <ac:grpSpMkLst>
            <pc:docMk/>
            <pc:sldMk cId="142087482" sldId="256"/>
            <ac:grpSpMk id="6" creationId="{8C5DBBD7-55A6-946B-AB2A-264B4B0360F2}"/>
          </ac:grpSpMkLst>
        </pc:grpChg>
        <pc:picChg chg="mod">
          <ac:chgData name="Héctor Cañeque Rufo" userId="6da3b7e2-2289-4c25-b14d-207ec07af19d" providerId="ADAL" clId="{BB2BB312-80ED-4364-8A09-0E6A01272F1B}" dt="2024-02-23T10:20:20.169" v="56" actId="14100"/>
          <ac:picMkLst>
            <pc:docMk/>
            <pc:sldMk cId="142087482" sldId="256"/>
            <ac:picMk id="5" creationId="{DE240BE7-99FA-FE76-4513-AAC830931EC9}"/>
          </ac:picMkLst>
        </pc:picChg>
        <pc:picChg chg="del">
          <ac:chgData name="Héctor Cañeque Rufo" userId="6da3b7e2-2289-4c25-b14d-207ec07af19d" providerId="ADAL" clId="{BB2BB312-80ED-4364-8A09-0E6A01272F1B}" dt="2024-02-23T10:17:59.339" v="0" actId="478"/>
          <ac:picMkLst>
            <pc:docMk/>
            <pc:sldMk cId="142087482" sldId="256"/>
            <ac:picMk id="56" creationId="{419BDEB6-8500-685D-DA03-3FA1B268C543}"/>
          </ac:picMkLst>
        </pc:picChg>
      </pc:sldChg>
    </pc:docChg>
  </pc:docChgLst>
  <pc:docChgLst>
    <pc:chgData name="Héctor Cañeque Rufo" userId="6da3b7e2-2289-4c25-b14d-207ec07af19d" providerId="ADAL" clId="{61F7DB94-1E22-4453-8E8B-97F7C82185E3}"/>
    <pc:docChg chg="undo custSel modSld">
      <pc:chgData name="Héctor Cañeque Rufo" userId="6da3b7e2-2289-4c25-b14d-207ec07af19d" providerId="ADAL" clId="{61F7DB94-1E22-4453-8E8B-97F7C82185E3}" dt="2024-02-20T10:28:37.982" v="3247" actId="20577"/>
      <pc:docMkLst>
        <pc:docMk/>
      </pc:docMkLst>
      <pc:sldChg chg="addSp delSp modSp mod modNotesTx">
        <pc:chgData name="Héctor Cañeque Rufo" userId="6da3b7e2-2289-4c25-b14d-207ec07af19d" providerId="ADAL" clId="{61F7DB94-1E22-4453-8E8B-97F7C82185E3}" dt="2024-02-20T10:28:37.982" v="3247" actId="20577"/>
        <pc:sldMkLst>
          <pc:docMk/>
          <pc:sldMk cId="142087482" sldId="256"/>
        </pc:sldMkLst>
        <pc:spChg chg="add mod">
          <ac:chgData name="Héctor Cañeque Rufo" userId="6da3b7e2-2289-4c25-b14d-207ec07af19d" providerId="ADAL" clId="{61F7DB94-1E22-4453-8E8B-97F7C82185E3}" dt="2024-01-30T17:24:51.559" v="1361" actId="1035"/>
          <ac:spMkLst>
            <pc:docMk/>
            <pc:sldMk cId="142087482" sldId="256"/>
            <ac:spMk id="4" creationId="{88067669-76CB-0D5B-023E-283311E9A6F0}"/>
          </ac:spMkLst>
        </pc:spChg>
        <pc:spChg chg="add mod">
          <ac:chgData name="Héctor Cañeque Rufo" userId="6da3b7e2-2289-4c25-b14d-207ec07af19d" providerId="ADAL" clId="{61F7DB94-1E22-4453-8E8B-97F7C82185E3}" dt="2024-01-30T17:24:51.559" v="1361" actId="1035"/>
          <ac:spMkLst>
            <pc:docMk/>
            <pc:sldMk cId="142087482" sldId="256"/>
            <ac:spMk id="9" creationId="{10B7A6CE-501F-E30A-E8B7-BDD9716D2D4A}"/>
          </ac:spMkLst>
        </pc:spChg>
        <pc:spChg chg="add mod">
          <ac:chgData name="Héctor Cañeque Rufo" userId="6da3b7e2-2289-4c25-b14d-207ec07af19d" providerId="ADAL" clId="{61F7DB94-1E22-4453-8E8B-97F7C82185E3}" dt="2024-01-30T17:24:51.559" v="1361" actId="1035"/>
          <ac:spMkLst>
            <pc:docMk/>
            <pc:sldMk cId="142087482" sldId="256"/>
            <ac:spMk id="11" creationId="{16A617D2-9461-18E2-8750-84DF3CACDCF2}"/>
          </ac:spMkLst>
        </pc:spChg>
        <pc:spChg chg="add mod">
          <ac:chgData name="Héctor Cañeque Rufo" userId="6da3b7e2-2289-4c25-b14d-207ec07af19d" providerId="ADAL" clId="{61F7DB94-1E22-4453-8E8B-97F7C82185E3}" dt="2024-01-30T17:24:51.559" v="1361" actId="1035"/>
          <ac:spMkLst>
            <pc:docMk/>
            <pc:sldMk cId="142087482" sldId="256"/>
            <ac:spMk id="13" creationId="{5E8EF11B-2D00-5A61-BAF7-31EC7E03D2BA}"/>
          </ac:spMkLst>
        </pc:spChg>
        <pc:spChg chg="mod">
          <ac:chgData name="Héctor Cañeque Rufo" userId="6da3b7e2-2289-4c25-b14d-207ec07af19d" providerId="ADAL" clId="{61F7DB94-1E22-4453-8E8B-97F7C82185E3}" dt="2024-01-30T17:24:51.559" v="1361" actId="1035"/>
          <ac:spMkLst>
            <pc:docMk/>
            <pc:sldMk cId="142087482" sldId="256"/>
            <ac:spMk id="15" creationId="{5B61CCD1-ABF1-D32F-6BAE-FA70EE4AC2D7}"/>
          </ac:spMkLst>
        </pc:spChg>
        <pc:spChg chg="mod">
          <ac:chgData name="Héctor Cañeque Rufo" userId="6da3b7e2-2289-4c25-b14d-207ec07af19d" providerId="ADAL" clId="{61F7DB94-1E22-4453-8E8B-97F7C82185E3}" dt="2024-01-30T17:24:51.559" v="1361" actId="1035"/>
          <ac:spMkLst>
            <pc:docMk/>
            <pc:sldMk cId="142087482" sldId="256"/>
            <ac:spMk id="16" creationId="{3669DA83-2DEC-0E63-6B35-9E93EB249398}"/>
          </ac:spMkLst>
        </pc:spChg>
        <pc:spChg chg="add mod">
          <ac:chgData name="Héctor Cañeque Rufo" userId="6da3b7e2-2289-4c25-b14d-207ec07af19d" providerId="ADAL" clId="{61F7DB94-1E22-4453-8E8B-97F7C82185E3}" dt="2024-01-30T17:24:51.559" v="1361" actId="1035"/>
          <ac:spMkLst>
            <pc:docMk/>
            <pc:sldMk cId="142087482" sldId="256"/>
            <ac:spMk id="17" creationId="{D76BE7A9-B512-11FD-3675-C94CF6F87D66}"/>
          </ac:spMkLst>
        </pc:spChg>
        <pc:spChg chg="add mod">
          <ac:chgData name="Héctor Cañeque Rufo" userId="6da3b7e2-2289-4c25-b14d-207ec07af19d" providerId="ADAL" clId="{61F7DB94-1E22-4453-8E8B-97F7C82185E3}" dt="2024-01-30T17:24:51.559" v="1361" actId="1035"/>
          <ac:spMkLst>
            <pc:docMk/>
            <pc:sldMk cId="142087482" sldId="256"/>
            <ac:spMk id="18" creationId="{11243C6C-66FB-7BC5-DEDB-6BBBF85ACF9A}"/>
          </ac:spMkLst>
        </pc:spChg>
        <pc:spChg chg="add mod">
          <ac:chgData name="Héctor Cañeque Rufo" userId="6da3b7e2-2289-4c25-b14d-207ec07af19d" providerId="ADAL" clId="{61F7DB94-1E22-4453-8E8B-97F7C82185E3}" dt="2024-01-30T17:24:51.559" v="1361" actId="1035"/>
          <ac:spMkLst>
            <pc:docMk/>
            <pc:sldMk cId="142087482" sldId="256"/>
            <ac:spMk id="19" creationId="{F5B81CC3-A9AA-CC7C-68C7-502B6723D4C9}"/>
          </ac:spMkLst>
        </pc:spChg>
        <pc:spChg chg="add mod">
          <ac:chgData name="Héctor Cañeque Rufo" userId="6da3b7e2-2289-4c25-b14d-207ec07af19d" providerId="ADAL" clId="{61F7DB94-1E22-4453-8E8B-97F7C82185E3}" dt="2024-01-30T17:24:51.559" v="1361" actId="1035"/>
          <ac:spMkLst>
            <pc:docMk/>
            <pc:sldMk cId="142087482" sldId="256"/>
            <ac:spMk id="20" creationId="{5C52686D-587B-05E2-379B-0287C8A9DE2A}"/>
          </ac:spMkLst>
        </pc:spChg>
        <pc:spChg chg="add mod">
          <ac:chgData name="Héctor Cañeque Rufo" userId="6da3b7e2-2289-4c25-b14d-207ec07af19d" providerId="ADAL" clId="{61F7DB94-1E22-4453-8E8B-97F7C82185E3}" dt="2024-01-30T17:24:51.559" v="1361" actId="1035"/>
          <ac:spMkLst>
            <pc:docMk/>
            <pc:sldMk cId="142087482" sldId="256"/>
            <ac:spMk id="21" creationId="{A0EAFA40-F17B-A680-2505-DD0858E97083}"/>
          </ac:spMkLst>
        </pc:spChg>
        <pc:spChg chg="add mod">
          <ac:chgData name="Héctor Cañeque Rufo" userId="6da3b7e2-2289-4c25-b14d-207ec07af19d" providerId="ADAL" clId="{61F7DB94-1E22-4453-8E8B-97F7C82185E3}" dt="2024-01-30T17:24:51.559" v="1361" actId="1035"/>
          <ac:spMkLst>
            <pc:docMk/>
            <pc:sldMk cId="142087482" sldId="256"/>
            <ac:spMk id="22" creationId="{28CD644B-5F8F-A2A1-36FB-9F610247C52A}"/>
          </ac:spMkLst>
        </pc:spChg>
        <pc:spChg chg="add mod">
          <ac:chgData name="Héctor Cañeque Rufo" userId="6da3b7e2-2289-4c25-b14d-207ec07af19d" providerId="ADAL" clId="{61F7DB94-1E22-4453-8E8B-97F7C82185E3}" dt="2024-01-30T17:24:51.559" v="1361" actId="1035"/>
          <ac:spMkLst>
            <pc:docMk/>
            <pc:sldMk cId="142087482" sldId="256"/>
            <ac:spMk id="23" creationId="{88DE1504-44FC-2EE7-A3C1-0F600720C6FF}"/>
          </ac:spMkLst>
        </pc:spChg>
        <pc:spChg chg="add mod">
          <ac:chgData name="Héctor Cañeque Rufo" userId="6da3b7e2-2289-4c25-b14d-207ec07af19d" providerId="ADAL" clId="{61F7DB94-1E22-4453-8E8B-97F7C82185E3}" dt="2024-01-30T17:24:51.559" v="1361" actId="1035"/>
          <ac:spMkLst>
            <pc:docMk/>
            <pc:sldMk cId="142087482" sldId="256"/>
            <ac:spMk id="24" creationId="{0169A0E0-F81E-4A83-0F98-5FFCEDE9628C}"/>
          </ac:spMkLst>
        </pc:spChg>
        <pc:spChg chg="add mod">
          <ac:chgData name="Héctor Cañeque Rufo" userId="6da3b7e2-2289-4c25-b14d-207ec07af19d" providerId="ADAL" clId="{61F7DB94-1E22-4453-8E8B-97F7C82185E3}" dt="2024-01-30T17:24:51.559" v="1361" actId="1035"/>
          <ac:spMkLst>
            <pc:docMk/>
            <pc:sldMk cId="142087482" sldId="256"/>
            <ac:spMk id="25" creationId="{EEE284C9-DB97-6E34-6423-7E77F594A46B}"/>
          </ac:spMkLst>
        </pc:spChg>
        <pc:spChg chg="add mod">
          <ac:chgData name="Héctor Cañeque Rufo" userId="6da3b7e2-2289-4c25-b14d-207ec07af19d" providerId="ADAL" clId="{61F7DB94-1E22-4453-8E8B-97F7C82185E3}" dt="2024-01-30T17:24:51.559" v="1361" actId="1035"/>
          <ac:spMkLst>
            <pc:docMk/>
            <pc:sldMk cId="142087482" sldId="256"/>
            <ac:spMk id="26" creationId="{56787995-2D3C-B661-8050-A0FFC6741DCF}"/>
          </ac:spMkLst>
        </pc:spChg>
        <pc:spChg chg="add mod">
          <ac:chgData name="Héctor Cañeque Rufo" userId="6da3b7e2-2289-4c25-b14d-207ec07af19d" providerId="ADAL" clId="{61F7DB94-1E22-4453-8E8B-97F7C82185E3}" dt="2024-01-30T17:24:51.559" v="1361" actId="1035"/>
          <ac:spMkLst>
            <pc:docMk/>
            <pc:sldMk cId="142087482" sldId="256"/>
            <ac:spMk id="27" creationId="{8F0230BC-F4FF-6F02-7E67-2D689E50FFE6}"/>
          </ac:spMkLst>
        </pc:spChg>
        <pc:spChg chg="add mod">
          <ac:chgData name="Héctor Cañeque Rufo" userId="6da3b7e2-2289-4c25-b14d-207ec07af19d" providerId="ADAL" clId="{61F7DB94-1E22-4453-8E8B-97F7C82185E3}" dt="2024-01-30T17:24:51.559" v="1361" actId="1035"/>
          <ac:spMkLst>
            <pc:docMk/>
            <pc:sldMk cId="142087482" sldId="256"/>
            <ac:spMk id="28" creationId="{67AEFD57-41E2-8BD9-4591-B7065CED7D90}"/>
          </ac:spMkLst>
        </pc:spChg>
        <pc:spChg chg="add mod">
          <ac:chgData name="Héctor Cañeque Rufo" userId="6da3b7e2-2289-4c25-b14d-207ec07af19d" providerId="ADAL" clId="{61F7DB94-1E22-4453-8E8B-97F7C82185E3}" dt="2024-01-30T17:24:51.559" v="1361" actId="1035"/>
          <ac:spMkLst>
            <pc:docMk/>
            <pc:sldMk cId="142087482" sldId="256"/>
            <ac:spMk id="30" creationId="{28DC1A67-62C3-C655-8D47-1F8797B507C5}"/>
          </ac:spMkLst>
        </pc:spChg>
        <pc:spChg chg="add mod">
          <ac:chgData name="Héctor Cañeque Rufo" userId="6da3b7e2-2289-4c25-b14d-207ec07af19d" providerId="ADAL" clId="{61F7DB94-1E22-4453-8E8B-97F7C82185E3}" dt="2024-01-30T17:24:51.559" v="1361" actId="1035"/>
          <ac:spMkLst>
            <pc:docMk/>
            <pc:sldMk cId="142087482" sldId="256"/>
            <ac:spMk id="31" creationId="{880E8D9A-AEEC-5F66-D713-E721D14868B3}"/>
          </ac:spMkLst>
        </pc:spChg>
        <pc:spChg chg="add mod">
          <ac:chgData name="Héctor Cañeque Rufo" userId="6da3b7e2-2289-4c25-b14d-207ec07af19d" providerId="ADAL" clId="{61F7DB94-1E22-4453-8E8B-97F7C82185E3}" dt="2024-01-30T17:24:51.559" v="1361" actId="1035"/>
          <ac:spMkLst>
            <pc:docMk/>
            <pc:sldMk cId="142087482" sldId="256"/>
            <ac:spMk id="32" creationId="{E554D646-3EA6-0964-D9AC-960627CAE6E6}"/>
          </ac:spMkLst>
        </pc:spChg>
        <pc:spChg chg="add mod">
          <ac:chgData name="Héctor Cañeque Rufo" userId="6da3b7e2-2289-4c25-b14d-207ec07af19d" providerId="ADAL" clId="{61F7DB94-1E22-4453-8E8B-97F7C82185E3}" dt="2024-01-30T17:24:51.559" v="1361" actId="1035"/>
          <ac:spMkLst>
            <pc:docMk/>
            <pc:sldMk cId="142087482" sldId="256"/>
            <ac:spMk id="33" creationId="{814BABDD-CE46-E35B-3C30-1B226946B9E4}"/>
          </ac:spMkLst>
        </pc:spChg>
        <pc:spChg chg="add mod">
          <ac:chgData name="Héctor Cañeque Rufo" userId="6da3b7e2-2289-4c25-b14d-207ec07af19d" providerId="ADAL" clId="{61F7DB94-1E22-4453-8E8B-97F7C82185E3}" dt="2024-01-30T17:24:51.559" v="1361" actId="1035"/>
          <ac:spMkLst>
            <pc:docMk/>
            <pc:sldMk cId="142087482" sldId="256"/>
            <ac:spMk id="34" creationId="{5B028912-63E7-7C3C-1230-3F50F56517D7}"/>
          </ac:spMkLst>
        </pc:spChg>
        <pc:spChg chg="add mod">
          <ac:chgData name="Héctor Cañeque Rufo" userId="6da3b7e2-2289-4c25-b14d-207ec07af19d" providerId="ADAL" clId="{61F7DB94-1E22-4453-8E8B-97F7C82185E3}" dt="2024-02-20T09:59:59.441" v="2995" actId="1036"/>
          <ac:spMkLst>
            <pc:docMk/>
            <pc:sldMk cId="142087482" sldId="256"/>
            <ac:spMk id="35" creationId="{BF1C3909-A22E-8F89-0001-1B4489C22476}"/>
          </ac:spMkLst>
        </pc:spChg>
        <pc:spChg chg="add mod">
          <ac:chgData name="Héctor Cañeque Rufo" userId="6da3b7e2-2289-4c25-b14d-207ec07af19d" providerId="ADAL" clId="{61F7DB94-1E22-4453-8E8B-97F7C82185E3}" dt="2024-01-30T17:24:51.559" v="1361" actId="1035"/>
          <ac:spMkLst>
            <pc:docMk/>
            <pc:sldMk cId="142087482" sldId="256"/>
            <ac:spMk id="36" creationId="{73FBAC0F-973B-42C9-84AF-E08A66C9001B}"/>
          </ac:spMkLst>
        </pc:spChg>
        <pc:spChg chg="add mod">
          <ac:chgData name="Héctor Cañeque Rufo" userId="6da3b7e2-2289-4c25-b14d-207ec07af19d" providerId="ADAL" clId="{61F7DB94-1E22-4453-8E8B-97F7C82185E3}" dt="2024-01-30T17:24:51.559" v="1361" actId="1035"/>
          <ac:spMkLst>
            <pc:docMk/>
            <pc:sldMk cId="142087482" sldId="256"/>
            <ac:spMk id="37" creationId="{503C1B7C-2EED-C2EB-266B-331EA7D29164}"/>
          </ac:spMkLst>
        </pc:spChg>
        <pc:spChg chg="add mod">
          <ac:chgData name="Héctor Cañeque Rufo" userId="6da3b7e2-2289-4c25-b14d-207ec07af19d" providerId="ADAL" clId="{61F7DB94-1E22-4453-8E8B-97F7C82185E3}" dt="2024-01-30T17:24:51.559" v="1361" actId="1035"/>
          <ac:spMkLst>
            <pc:docMk/>
            <pc:sldMk cId="142087482" sldId="256"/>
            <ac:spMk id="38" creationId="{CD70A6C3-4362-11F3-D29F-BDCC6EA9DA71}"/>
          </ac:spMkLst>
        </pc:spChg>
        <pc:spChg chg="add mod">
          <ac:chgData name="Héctor Cañeque Rufo" userId="6da3b7e2-2289-4c25-b14d-207ec07af19d" providerId="ADAL" clId="{61F7DB94-1E22-4453-8E8B-97F7C82185E3}" dt="2024-01-30T17:24:51.559" v="1361" actId="1035"/>
          <ac:spMkLst>
            <pc:docMk/>
            <pc:sldMk cId="142087482" sldId="256"/>
            <ac:spMk id="39" creationId="{BE0DD912-C19B-B368-D7C9-04C53F1D5C7C}"/>
          </ac:spMkLst>
        </pc:spChg>
        <pc:spChg chg="add mod">
          <ac:chgData name="Héctor Cañeque Rufo" userId="6da3b7e2-2289-4c25-b14d-207ec07af19d" providerId="ADAL" clId="{61F7DB94-1E22-4453-8E8B-97F7C82185E3}" dt="2024-01-30T17:24:51.559" v="1361" actId="1035"/>
          <ac:spMkLst>
            <pc:docMk/>
            <pc:sldMk cId="142087482" sldId="256"/>
            <ac:spMk id="40" creationId="{48C60739-F142-7ACE-13D9-DC5D9926A1C3}"/>
          </ac:spMkLst>
        </pc:spChg>
        <pc:spChg chg="add del mod">
          <ac:chgData name="Héctor Cañeque Rufo" userId="6da3b7e2-2289-4c25-b14d-207ec07af19d" providerId="ADAL" clId="{61F7DB94-1E22-4453-8E8B-97F7C82185E3}" dt="2024-01-30T17:16:23.349" v="776" actId="478"/>
          <ac:spMkLst>
            <pc:docMk/>
            <pc:sldMk cId="142087482" sldId="256"/>
            <ac:spMk id="41" creationId="{13CF7D2D-746A-1E98-5492-08C7FA5304A4}"/>
          </ac:spMkLst>
        </pc:spChg>
        <pc:spChg chg="add del mod">
          <ac:chgData name="Héctor Cañeque Rufo" userId="6da3b7e2-2289-4c25-b14d-207ec07af19d" providerId="ADAL" clId="{61F7DB94-1E22-4453-8E8B-97F7C82185E3}" dt="2024-01-30T17:16:23.349" v="776" actId="478"/>
          <ac:spMkLst>
            <pc:docMk/>
            <pc:sldMk cId="142087482" sldId="256"/>
            <ac:spMk id="42" creationId="{07473B95-4973-F2F0-E97B-B237F38F4DAB}"/>
          </ac:spMkLst>
        </pc:spChg>
        <pc:spChg chg="add del mod">
          <ac:chgData name="Héctor Cañeque Rufo" userId="6da3b7e2-2289-4c25-b14d-207ec07af19d" providerId="ADAL" clId="{61F7DB94-1E22-4453-8E8B-97F7C82185E3}" dt="2024-01-31T09:45:10.846" v="1756" actId="478"/>
          <ac:spMkLst>
            <pc:docMk/>
            <pc:sldMk cId="142087482" sldId="256"/>
            <ac:spMk id="42" creationId="{4CE87673-FD9D-1F7B-947C-3C7A21E7F668}"/>
          </ac:spMkLst>
        </pc:spChg>
        <pc:spChg chg="add mod">
          <ac:chgData name="Héctor Cañeque Rufo" userId="6da3b7e2-2289-4c25-b14d-207ec07af19d" providerId="ADAL" clId="{61F7DB94-1E22-4453-8E8B-97F7C82185E3}" dt="2024-01-31T10:01:52.629" v="2738" actId="164"/>
          <ac:spMkLst>
            <pc:docMk/>
            <pc:sldMk cId="142087482" sldId="256"/>
            <ac:spMk id="43" creationId="{820EF988-F816-B37E-0F32-360848B373F2}"/>
          </ac:spMkLst>
        </pc:spChg>
        <pc:spChg chg="add mod">
          <ac:chgData name="Héctor Cañeque Rufo" userId="6da3b7e2-2289-4c25-b14d-207ec07af19d" providerId="ADAL" clId="{61F7DB94-1E22-4453-8E8B-97F7C82185E3}" dt="2024-01-30T17:24:51.559" v="1361" actId="1035"/>
          <ac:spMkLst>
            <pc:docMk/>
            <pc:sldMk cId="142087482" sldId="256"/>
            <ac:spMk id="44" creationId="{3808C2CA-69A2-7028-3BB4-CF8E509230D9}"/>
          </ac:spMkLst>
        </pc:spChg>
        <pc:spChg chg="add mod">
          <ac:chgData name="Héctor Cañeque Rufo" userId="6da3b7e2-2289-4c25-b14d-207ec07af19d" providerId="ADAL" clId="{61F7DB94-1E22-4453-8E8B-97F7C82185E3}" dt="2024-01-30T17:24:51.559" v="1361" actId="1035"/>
          <ac:spMkLst>
            <pc:docMk/>
            <pc:sldMk cId="142087482" sldId="256"/>
            <ac:spMk id="45" creationId="{153F091A-41BF-3AC7-3B46-628A8B9DE8B0}"/>
          </ac:spMkLst>
        </pc:spChg>
        <pc:spChg chg="add mod">
          <ac:chgData name="Héctor Cañeque Rufo" userId="6da3b7e2-2289-4c25-b14d-207ec07af19d" providerId="ADAL" clId="{61F7DB94-1E22-4453-8E8B-97F7C82185E3}" dt="2024-01-30T17:24:51.559" v="1361" actId="1035"/>
          <ac:spMkLst>
            <pc:docMk/>
            <pc:sldMk cId="142087482" sldId="256"/>
            <ac:spMk id="46" creationId="{D5EA56CF-350E-57AD-588D-EBB667B688C4}"/>
          </ac:spMkLst>
        </pc:spChg>
        <pc:spChg chg="add mod">
          <ac:chgData name="Héctor Cañeque Rufo" userId="6da3b7e2-2289-4c25-b14d-207ec07af19d" providerId="ADAL" clId="{61F7DB94-1E22-4453-8E8B-97F7C82185E3}" dt="2024-02-20T10:00:07.127" v="3006" actId="1036"/>
          <ac:spMkLst>
            <pc:docMk/>
            <pc:sldMk cId="142087482" sldId="256"/>
            <ac:spMk id="47" creationId="{8D4F7BC0-53AB-5173-5E59-BCBE70E2DE44}"/>
          </ac:spMkLst>
        </pc:spChg>
        <pc:spChg chg="add mod">
          <ac:chgData name="Héctor Cañeque Rufo" userId="6da3b7e2-2289-4c25-b14d-207ec07af19d" providerId="ADAL" clId="{61F7DB94-1E22-4453-8E8B-97F7C82185E3}" dt="2024-02-20T10:00:07.127" v="3006" actId="1036"/>
          <ac:spMkLst>
            <pc:docMk/>
            <pc:sldMk cId="142087482" sldId="256"/>
            <ac:spMk id="48" creationId="{1D496425-76CA-2A19-2F33-A486884CB010}"/>
          </ac:spMkLst>
        </pc:spChg>
        <pc:spChg chg="add mod">
          <ac:chgData name="Héctor Cañeque Rufo" userId="6da3b7e2-2289-4c25-b14d-207ec07af19d" providerId="ADAL" clId="{61F7DB94-1E22-4453-8E8B-97F7C82185E3}" dt="2024-01-31T10:01:52.629" v="2738" actId="164"/>
          <ac:spMkLst>
            <pc:docMk/>
            <pc:sldMk cId="142087482" sldId="256"/>
            <ac:spMk id="49" creationId="{3A88AA24-3D85-FE84-0CF0-1DBFDB457513}"/>
          </ac:spMkLst>
        </pc:spChg>
        <pc:spChg chg="add mod">
          <ac:chgData name="Héctor Cañeque Rufo" userId="6da3b7e2-2289-4c25-b14d-207ec07af19d" providerId="ADAL" clId="{61F7DB94-1E22-4453-8E8B-97F7C82185E3}" dt="2024-01-31T10:01:52.629" v="2738" actId="164"/>
          <ac:spMkLst>
            <pc:docMk/>
            <pc:sldMk cId="142087482" sldId="256"/>
            <ac:spMk id="52" creationId="{996315A0-2696-0316-1BFD-C09C4499703D}"/>
          </ac:spMkLst>
        </pc:spChg>
        <pc:spChg chg="add mod">
          <ac:chgData name="Héctor Cañeque Rufo" userId="6da3b7e2-2289-4c25-b14d-207ec07af19d" providerId="ADAL" clId="{61F7DB94-1E22-4453-8E8B-97F7C82185E3}" dt="2024-01-31T10:01:52.629" v="2738" actId="164"/>
          <ac:spMkLst>
            <pc:docMk/>
            <pc:sldMk cId="142087482" sldId="256"/>
            <ac:spMk id="53" creationId="{2A5921E6-EA6D-C407-B87D-B89FC8CDD97F}"/>
          </ac:spMkLst>
        </pc:spChg>
        <pc:grpChg chg="add mod">
          <ac:chgData name="Héctor Cañeque Rufo" userId="6da3b7e2-2289-4c25-b14d-207ec07af19d" providerId="ADAL" clId="{61F7DB94-1E22-4453-8E8B-97F7C82185E3}" dt="2024-02-20T10:02:41.904" v="3132" actId="164"/>
          <ac:grpSpMkLst>
            <pc:docMk/>
            <pc:sldMk cId="142087482" sldId="256"/>
            <ac:grpSpMk id="6" creationId="{8C5DBBD7-55A6-946B-AB2A-264B4B0360F2}"/>
          </ac:grpSpMkLst>
        </pc:grpChg>
        <pc:grpChg chg="del mod">
          <ac:chgData name="Héctor Cañeque Rufo" userId="6da3b7e2-2289-4c25-b14d-207ec07af19d" providerId="ADAL" clId="{61F7DB94-1E22-4453-8E8B-97F7C82185E3}" dt="2024-01-31T10:04:34.761" v="2946" actId="478"/>
          <ac:grpSpMkLst>
            <pc:docMk/>
            <pc:sldMk cId="142087482" sldId="256"/>
            <ac:grpSpMk id="8" creationId="{BC187489-38D5-F75F-D041-18A3548D47AB}"/>
          </ac:grpSpMkLst>
        </pc:grpChg>
        <pc:grpChg chg="add del mod">
          <ac:chgData name="Héctor Cañeque Rufo" userId="6da3b7e2-2289-4c25-b14d-207ec07af19d" providerId="ADAL" clId="{61F7DB94-1E22-4453-8E8B-97F7C82185E3}" dt="2024-01-31T10:02:19.966" v="2739" actId="478"/>
          <ac:grpSpMkLst>
            <pc:docMk/>
            <pc:sldMk cId="142087482" sldId="256"/>
            <ac:grpSpMk id="54" creationId="{07DD49C2-2D42-53A9-1A1B-A21F728D7216}"/>
          </ac:grpSpMkLst>
        </pc:grpChg>
        <pc:picChg chg="add mod ord modCrop">
          <ac:chgData name="Héctor Cañeque Rufo" userId="6da3b7e2-2289-4c25-b14d-207ec07af19d" providerId="ADAL" clId="{61F7DB94-1E22-4453-8E8B-97F7C82185E3}" dt="2024-01-30T17:24:51.559" v="1361" actId="1035"/>
          <ac:picMkLst>
            <pc:docMk/>
            <pc:sldMk cId="142087482" sldId="256"/>
            <ac:picMk id="2" creationId="{33E933C6-A531-8CBD-F1AF-449B7750A886}"/>
          </ac:picMkLst>
        </pc:picChg>
        <pc:picChg chg="mod modCrop">
          <ac:chgData name="Héctor Cañeque Rufo" userId="6da3b7e2-2289-4c25-b14d-207ec07af19d" providerId="ADAL" clId="{61F7DB94-1E22-4453-8E8B-97F7C82185E3}" dt="2024-01-30T17:24:51.559" v="1361" actId="1035"/>
          <ac:picMkLst>
            <pc:docMk/>
            <pc:sldMk cId="142087482" sldId="256"/>
            <ac:picMk id="3" creationId="{AF25BC8C-0FC5-BCE0-B03B-FC28105B1AA2}"/>
          </ac:picMkLst>
        </pc:picChg>
        <pc:picChg chg="del mod">
          <ac:chgData name="Héctor Cañeque Rufo" userId="6da3b7e2-2289-4c25-b14d-207ec07af19d" providerId="ADAL" clId="{61F7DB94-1E22-4453-8E8B-97F7C82185E3}" dt="2024-01-31T10:04:32.399" v="2945" actId="478"/>
          <ac:picMkLst>
            <pc:docMk/>
            <pc:sldMk cId="142087482" sldId="256"/>
            <ac:picMk id="5" creationId="{841BC414-74E4-2FA5-C99C-142E2E825EA5}"/>
          </ac:picMkLst>
        </pc:picChg>
        <pc:picChg chg="add mod ord">
          <ac:chgData name="Héctor Cañeque Rufo" userId="6da3b7e2-2289-4c25-b14d-207ec07af19d" providerId="ADAL" clId="{61F7DB94-1E22-4453-8E8B-97F7C82185E3}" dt="2024-02-20T10:04:01.627" v="3147" actId="1037"/>
          <ac:picMkLst>
            <pc:docMk/>
            <pc:sldMk cId="142087482" sldId="256"/>
            <ac:picMk id="5" creationId="{DE240BE7-99FA-FE76-4513-AAC830931EC9}"/>
          </ac:picMkLst>
        </pc:picChg>
        <pc:picChg chg="add del mod">
          <ac:chgData name="Héctor Cañeque Rufo" userId="6da3b7e2-2289-4c25-b14d-207ec07af19d" providerId="ADAL" clId="{61F7DB94-1E22-4453-8E8B-97F7C82185E3}" dt="2024-02-20T10:03:29.972" v="3138" actId="478"/>
          <ac:picMkLst>
            <pc:docMk/>
            <pc:sldMk cId="142087482" sldId="256"/>
            <ac:picMk id="7" creationId="{66D0C6ED-03C1-5CB2-3719-1267C487BF19}"/>
          </ac:picMkLst>
        </pc:picChg>
        <pc:picChg chg="mod">
          <ac:chgData name="Héctor Cañeque Rufo" userId="6da3b7e2-2289-4c25-b14d-207ec07af19d" providerId="ADAL" clId="{61F7DB94-1E22-4453-8E8B-97F7C82185E3}" dt="2024-01-30T17:24:51.559" v="1361" actId="1035"/>
          <ac:picMkLst>
            <pc:docMk/>
            <pc:sldMk cId="142087482" sldId="256"/>
            <ac:picMk id="10" creationId="{2CC8152F-C344-AA1B-CB40-023C86D4DC28}"/>
          </ac:picMkLst>
        </pc:picChg>
        <pc:picChg chg="add del mod">
          <ac:chgData name="Héctor Cañeque Rufo" userId="6da3b7e2-2289-4c25-b14d-207ec07af19d" providerId="ADAL" clId="{61F7DB94-1E22-4453-8E8B-97F7C82185E3}" dt="2024-01-31T09:44:06.335" v="1622" actId="478"/>
          <ac:picMkLst>
            <pc:docMk/>
            <pc:sldMk cId="142087482" sldId="256"/>
            <ac:picMk id="12" creationId="{1708C41E-E8AD-33E1-FA1B-927EB879CAB1}"/>
          </ac:picMkLst>
        </pc:picChg>
        <pc:picChg chg="del mod modCrop">
          <ac:chgData name="Héctor Cañeque Rufo" userId="6da3b7e2-2289-4c25-b14d-207ec07af19d" providerId="ADAL" clId="{61F7DB94-1E22-4453-8E8B-97F7C82185E3}" dt="2024-01-30T17:20:34.454" v="913" actId="478"/>
          <ac:picMkLst>
            <pc:docMk/>
            <pc:sldMk cId="142087482" sldId="256"/>
            <ac:picMk id="12" creationId="{D86D94EA-A12C-9981-802E-B2A2F069A561}"/>
          </ac:picMkLst>
        </pc:picChg>
        <pc:picChg chg="mod">
          <ac:chgData name="Héctor Cañeque Rufo" userId="6da3b7e2-2289-4c25-b14d-207ec07af19d" providerId="ADAL" clId="{61F7DB94-1E22-4453-8E8B-97F7C82185E3}" dt="2024-01-30T17:24:51.559" v="1361" actId="1035"/>
          <ac:picMkLst>
            <pc:docMk/>
            <pc:sldMk cId="142087482" sldId="256"/>
            <ac:picMk id="14" creationId="{9106E4EB-59A6-7242-95BC-B06349CC5925}"/>
          </ac:picMkLst>
        </pc:picChg>
        <pc:picChg chg="mod modCrop">
          <ac:chgData name="Héctor Cañeque Rufo" userId="6da3b7e2-2289-4c25-b14d-207ec07af19d" providerId="ADAL" clId="{61F7DB94-1E22-4453-8E8B-97F7C82185E3}" dt="2024-02-20T10:04:16.418" v="3149" actId="732"/>
          <ac:picMkLst>
            <pc:docMk/>
            <pc:sldMk cId="142087482" sldId="256"/>
            <ac:picMk id="29" creationId="{83DE1B8E-C055-E29F-EB9B-88C580321E1E}"/>
          </ac:picMkLst>
        </pc:picChg>
        <pc:picChg chg="add del mod">
          <ac:chgData name="Héctor Cañeque Rufo" userId="6da3b7e2-2289-4c25-b14d-207ec07af19d" providerId="ADAL" clId="{61F7DB94-1E22-4453-8E8B-97F7C82185E3}" dt="2024-01-31T09:59:52.555" v="2431" actId="478"/>
          <ac:picMkLst>
            <pc:docMk/>
            <pc:sldMk cId="142087482" sldId="256"/>
            <ac:picMk id="41" creationId="{EA3BCC40-8B2B-F39C-AB48-880C35B95D59}"/>
          </ac:picMkLst>
        </pc:picChg>
        <pc:picChg chg="add mod ord">
          <ac:chgData name="Héctor Cañeque Rufo" userId="6da3b7e2-2289-4c25-b14d-207ec07af19d" providerId="ADAL" clId="{61F7DB94-1E22-4453-8E8B-97F7C82185E3}" dt="2024-01-31T10:01:52.629" v="2738" actId="164"/>
          <ac:picMkLst>
            <pc:docMk/>
            <pc:sldMk cId="142087482" sldId="256"/>
            <ac:picMk id="50" creationId="{0569A85E-7070-51F6-AF13-B08D5CE72721}"/>
          </ac:picMkLst>
        </pc:picChg>
        <pc:picChg chg="add del mod">
          <ac:chgData name="Héctor Cañeque Rufo" userId="6da3b7e2-2289-4c25-b14d-207ec07af19d" providerId="ADAL" clId="{61F7DB94-1E22-4453-8E8B-97F7C82185E3}" dt="2024-01-31T09:59:17.339" v="2328" actId="478"/>
          <ac:picMkLst>
            <pc:docMk/>
            <pc:sldMk cId="142087482" sldId="256"/>
            <ac:picMk id="51" creationId="{461091A5-1EB7-8CE8-0B6F-80C6D825615B}"/>
          </ac:picMkLst>
        </pc:picChg>
        <pc:picChg chg="add mod">
          <ac:chgData name="Héctor Cañeque Rufo" userId="6da3b7e2-2289-4c25-b14d-207ec07af19d" providerId="ADAL" clId="{61F7DB94-1E22-4453-8E8B-97F7C82185E3}" dt="2024-02-20T10:00:07.127" v="3006" actId="1036"/>
          <ac:picMkLst>
            <pc:docMk/>
            <pc:sldMk cId="142087482" sldId="256"/>
            <ac:picMk id="56" creationId="{419BDEB6-8500-685D-DA03-3FA1B268C543}"/>
          </ac:picMkLst>
        </pc:picChg>
      </pc:sldChg>
    </pc:docChg>
  </pc:docChgLst>
  <pc:docChgLst>
    <pc:chgData name="Héctor Cañeque Rufo" userId="6da3b7e2-2289-4c25-b14d-207ec07af19d" providerId="ADAL" clId="{928657C9-AE4A-4530-B9C4-A0CC3C8F8204}"/>
    <pc:docChg chg="undo custSel addSld modSld">
      <pc:chgData name="Héctor Cañeque Rufo" userId="6da3b7e2-2289-4c25-b14d-207ec07af19d" providerId="ADAL" clId="{928657C9-AE4A-4530-B9C4-A0CC3C8F8204}" dt="2024-01-30T15:30:34.285" v="2030" actId="1036"/>
      <pc:docMkLst>
        <pc:docMk/>
      </pc:docMkLst>
      <pc:sldChg chg="addSp delSp modSp new mod">
        <pc:chgData name="Héctor Cañeque Rufo" userId="6da3b7e2-2289-4c25-b14d-207ec07af19d" providerId="ADAL" clId="{928657C9-AE4A-4530-B9C4-A0CC3C8F8204}" dt="2024-01-30T15:30:34.285" v="2030" actId="1036"/>
        <pc:sldMkLst>
          <pc:docMk/>
          <pc:sldMk cId="142087482" sldId="256"/>
        </pc:sldMkLst>
        <pc:spChg chg="del">
          <ac:chgData name="Héctor Cañeque Rufo" userId="6da3b7e2-2289-4c25-b14d-207ec07af19d" providerId="ADAL" clId="{928657C9-AE4A-4530-B9C4-A0CC3C8F8204}" dt="2024-01-28T12:42:15.071" v="1" actId="478"/>
          <ac:spMkLst>
            <pc:docMk/>
            <pc:sldMk cId="142087482" sldId="256"/>
            <ac:spMk id="2" creationId="{6CD2DB57-EA20-C6E2-FE84-83084F67B2F8}"/>
          </ac:spMkLst>
        </pc:spChg>
        <pc:spChg chg="del">
          <ac:chgData name="Héctor Cañeque Rufo" userId="6da3b7e2-2289-4c25-b14d-207ec07af19d" providerId="ADAL" clId="{928657C9-AE4A-4530-B9C4-A0CC3C8F8204}" dt="2024-01-28T12:42:16.822" v="2" actId="478"/>
          <ac:spMkLst>
            <pc:docMk/>
            <pc:sldMk cId="142087482" sldId="256"/>
            <ac:spMk id="3" creationId="{37C38ECF-838F-FADD-2638-059D5FB4B0FE}"/>
          </ac:spMkLst>
        </pc:spChg>
        <pc:spChg chg="add mod">
          <ac:chgData name="Héctor Cañeque Rufo" userId="6da3b7e2-2289-4c25-b14d-207ec07af19d" providerId="ADAL" clId="{928657C9-AE4A-4530-B9C4-A0CC3C8F8204}" dt="2024-01-30T15:29:28.431" v="1972" actId="164"/>
          <ac:spMkLst>
            <pc:docMk/>
            <pc:sldMk cId="142087482" sldId="256"/>
            <ac:spMk id="4" creationId="{766EB0A8-8730-F72A-0365-D91AE6EFF634}"/>
          </ac:spMkLst>
        </pc:spChg>
        <pc:spChg chg="add mod">
          <ac:chgData name="Héctor Cañeque Rufo" userId="6da3b7e2-2289-4c25-b14d-207ec07af19d" providerId="ADAL" clId="{928657C9-AE4A-4530-B9C4-A0CC3C8F8204}" dt="2024-01-30T15:29:28.431" v="1972" actId="164"/>
          <ac:spMkLst>
            <pc:docMk/>
            <pc:sldMk cId="142087482" sldId="256"/>
            <ac:spMk id="11" creationId="{19062171-D886-7CDF-EEFA-7D97F3CC98AD}"/>
          </ac:spMkLst>
        </pc:spChg>
        <pc:spChg chg="add mod">
          <ac:chgData name="Héctor Cañeque Rufo" userId="6da3b7e2-2289-4c25-b14d-207ec07af19d" providerId="ADAL" clId="{928657C9-AE4A-4530-B9C4-A0CC3C8F8204}" dt="2024-01-30T15:29:28.431" v="1972" actId="164"/>
          <ac:spMkLst>
            <pc:docMk/>
            <pc:sldMk cId="142087482" sldId="256"/>
            <ac:spMk id="13" creationId="{BA8BEAAE-97A5-EEF1-4FF4-19A0041B71CD}"/>
          </ac:spMkLst>
        </pc:spChg>
        <pc:spChg chg="add mod">
          <ac:chgData name="Héctor Cañeque Rufo" userId="6da3b7e2-2289-4c25-b14d-207ec07af19d" providerId="ADAL" clId="{928657C9-AE4A-4530-B9C4-A0CC3C8F8204}" dt="2024-01-29T11:51:47.822" v="690" actId="1036"/>
          <ac:spMkLst>
            <pc:docMk/>
            <pc:sldMk cId="142087482" sldId="256"/>
            <ac:spMk id="15" creationId="{5B61CCD1-ABF1-D32F-6BAE-FA70EE4AC2D7}"/>
          </ac:spMkLst>
        </pc:spChg>
        <pc:spChg chg="add mod">
          <ac:chgData name="Héctor Cañeque Rufo" userId="6da3b7e2-2289-4c25-b14d-207ec07af19d" providerId="ADAL" clId="{928657C9-AE4A-4530-B9C4-A0CC3C8F8204}" dt="2024-01-29T11:51:47.822" v="690" actId="1036"/>
          <ac:spMkLst>
            <pc:docMk/>
            <pc:sldMk cId="142087482" sldId="256"/>
            <ac:spMk id="16" creationId="{3669DA83-2DEC-0E63-6B35-9E93EB249398}"/>
          </ac:spMkLst>
        </pc:spChg>
        <pc:spChg chg="add mod">
          <ac:chgData name="Héctor Cañeque Rufo" userId="6da3b7e2-2289-4c25-b14d-207ec07af19d" providerId="ADAL" clId="{928657C9-AE4A-4530-B9C4-A0CC3C8F8204}" dt="2024-01-30T15:29:28.431" v="1972" actId="164"/>
          <ac:spMkLst>
            <pc:docMk/>
            <pc:sldMk cId="142087482" sldId="256"/>
            <ac:spMk id="17" creationId="{9E1A8B40-803B-1C56-5FF2-B7BBDE536ECD}"/>
          </ac:spMkLst>
        </pc:spChg>
        <pc:spChg chg="add mod">
          <ac:chgData name="Héctor Cañeque Rufo" userId="6da3b7e2-2289-4c25-b14d-207ec07af19d" providerId="ADAL" clId="{928657C9-AE4A-4530-B9C4-A0CC3C8F8204}" dt="2024-01-30T15:29:28.431" v="1972" actId="164"/>
          <ac:spMkLst>
            <pc:docMk/>
            <pc:sldMk cId="142087482" sldId="256"/>
            <ac:spMk id="18" creationId="{9B9E750F-309C-92A9-9F3E-618638FAE9B4}"/>
          </ac:spMkLst>
        </pc:spChg>
        <pc:spChg chg="add mod">
          <ac:chgData name="Héctor Cañeque Rufo" userId="6da3b7e2-2289-4c25-b14d-207ec07af19d" providerId="ADAL" clId="{928657C9-AE4A-4530-B9C4-A0CC3C8F8204}" dt="2024-01-30T15:29:28.431" v="1972" actId="164"/>
          <ac:spMkLst>
            <pc:docMk/>
            <pc:sldMk cId="142087482" sldId="256"/>
            <ac:spMk id="19" creationId="{CA6D327C-80CB-9063-453C-B1C055B7D5A9}"/>
          </ac:spMkLst>
        </pc:spChg>
        <pc:spChg chg="add mod">
          <ac:chgData name="Héctor Cañeque Rufo" userId="6da3b7e2-2289-4c25-b14d-207ec07af19d" providerId="ADAL" clId="{928657C9-AE4A-4530-B9C4-A0CC3C8F8204}" dt="2024-01-30T15:29:28.431" v="1972" actId="164"/>
          <ac:spMkLst>
            <pc:docMk/>
            <pc:sldMk cId="142087482" sldId="256"/>
            <ac:spMk id="20" creationId="{12C87CF0-86C7-DF18-2A1D-D0C96CEDE183}"/>
          </ac:spMkLst>
        </pc:spChg>
        <pc:spChg chg="add mod">
          <ac:chgData name="Héctor Cañeque Rufo" userId="6da3b7e2-2289-4c25-b14d-207ec07af19d" providerId="ADAL" clId="{928657C9-AE4A-4530-B9C4-A0CC3C8F8204}" dt="2024-01-30T15:29:28.431" v="1972" actId="164"/>
          <ac:spMkLst>
            <pc:docMk/>
            <pc:sldMk cId="142087482" sldId="256"/>
            <ac:spMk id="21" creationId="{C661DA89-7537-7EBE-93A1-04E4437740AA}"/>
          </ac:spMkLst>
        </pc:spChg>
        <pc:spChg chg="add mod">
          <ac:chgData name="Héctor Cañeque Rufo" userId="6da3b7e2-2289-4c25-b14d-207ec07af19d" providerId="ADAL" clId="{928657C9-AE4A-4530-B9C4-A0CC3C8F8204}" dt="2024-01-30T15:29:28.431" v="1972" actId="164"/>
          <ac:spMkLst>
            <pc:docMk/>
            <pc:sldMk cId="142087482" sldId="256"/>
            <ac:spMk id="23" creationId="{8A7700D2-CE69-00BA-05DE-31CD2FAF300B}"/>
          </ac:spMkLst>
        </pc:spChg>
        <pc:spChg chg="add mod">
          <ac:chgData name="Héctor Cañeque Rufo" userId="6da3b7e2-2289-4c25-b14d-207ec07af19d" providerId="ADAL" clId="{928657C9-AE4A-4530-B9C4-A0CC3C8F8204}" dt="2024-01-30T15:29:28.431" v="1972" actId="164"/>
          <ac:spMkLst>
            <pc:docMk/>
            <pc:sldMk cId="142087482" sldId="256"/>
            <ac:spMk id="24" creationId="{C3DE6A63-AB6C-DF60-960F-863CAEE9442D}"/>
          </ac:spMkLst>
        </pc:spChg>
        <pc:spChg chg="add mod">
          <ac:chgData name="Héctor Cañeque Rufo" userId="6da3b7e2-2289-4c25-b14d-207ec07af19d" providerId="ADAL" clId="{928657C9-AE4A-4530-B9C4-A0CC3C8F8204}" dt="2024-01-30T15:29:28.431" v="1972" actId="164"/>
          <ac:spMkLst>
            <pc:docMk/>
            <pc:sldMk cId="142087482" sldId="256"/>
            <ac:spMk id="25" creationId="{50530089-AFAF-8A97-03D7-7E3E100CD6F0}"/>
          </ac:spMkLst>
        </pc:spChg>
        <pc:spChg chg="add mod">
          <ac:chgData name="Héctor Cañeque Rufo" userId="6da3b7e2-2289-4c25-b14d-207ec07af19d" providerId="ADAL" clId="{928657C9-AE4A-4530-B9C4-A0CC3C8F8204}" dt="2024-01-30T15:29:28.431" v="1972" actId="164"/>
          <ac:spMkLst>
            <pc:docMk/>
            <pc:sldMk cId="142087482" sldId="256"/>
            <ac:spMk id="26" creationId="{CC23EB23-7150-D292-0B40-6FE4FDFE56F1}"/>
          </ac:spMkLst>
        </pc:spChg>
        <pc:grpChg chg="add mod">
          <ac:chgData name="Héctor Cañeque Rufo" userId="6da3b7e2-2289-4c25-b14d-207ec07af19d" providerId="ADAL" clId="{928657C9-AE4A-4530-B9C4-A0CC3C8F8204}" dt="2024-01-29T11:51:47.822" v="690" actId="1036"/>
          <ac:grpSpMkLst>
            <pc:docMk/>
            <pc:sldMk cId="142087482" sldId="256"/>
            <ac:grpSpMk id="8" creationId="{BC187489-38D5-F75F-D041-18A3548D47AB}"/>
          </ac:grpSpMkLst>
        </pc:grpChg>
        <pc:grpChg chg="add del mod">
          <ac:chgData name="Héctor Cañeque Rufo" userId="6da3b7e2-2289-4c25-b14d-207ec07af19d" providerId="ADAL" clId="{928657C9-AE4A-4530-B9C4-A0CC3C8F8204}" dt="2024-01-30T15:30:23.100" v="2012" actId="478"/>
          <ac:grpSpMkLst>
            <pc:docMk/>
            <pc:sldMk cId="142087482" sldId="256"/>
            <ac:grpSpMk id="27" creationId="{6578313F-FFBE-E10E-E62D-4DE164CE8991}"/>
          </ac:grpSpMkLst>
        </pc:grpChg>
        <pc:picChg chg="add del mod ord">
          <ac:chgData name="Héctor Cañeque Rufo" userId="6da3b7e2-2289-4c25-b14d-207ec07af19d" providerId="ADAL" clId="{928657C9-AE4A-4530-B9C4-A0CC3C8F8204}" dt="2024-01-30T15:26:46.820" v="1708" actId="478"/>
          <ac:picMkLst>
            <pc:docMk/>
            <pc:sldMk cId="142087482" sldId="256"/>
            <ac:picMk id="2" creationId="{7D762B89-E861-C1A3-3EB0-B913B082FB28}"/>
          </ac:picMkLst>
        </pc:picChg>
        <pc:picChg chg="add mod">
          <ac:chgData name="Héctor Cañeque Rufo" userId="6da3b7e2-2289-4c25-b14d-207ec07af19d" providerId="ADAL" clId="{928657C9-AE4A-4530-B9C4-A0CC3C8F8204}" dt="2024-01-29T11:51:47.822" v="690" actId="1036"/>
          <ac:picMkLst>
            <pc:docMk/>
            <pc:sldMk cId="142087482" sldId="256"/>
            <ac:picMk id="3" creationId="{AF25BC8C-0FC5-BCE0-B03B-FC28105B1AA2}"/>
          </ac:picMkLst>
        </pc:picChg>
        <pc:picChg chg="add mod modCrop">
          <ac:chgData name="Héctor Cañeque Rufo" userId="6da3b7e2-2289-4c25-b14d-207ec07af19d" providerId="ADAL" clId="{928657C9-AE4A-4530-B9C4-A0CC3C8F8204}" dt="2024-01-29T11:51:47.822" v="690" actId="1036"/>
          <ac:picMkLst>
            <pc:docMk/>
            <pc:sldMk cId="142087482" sldId="256"/>
            <ac:picMk id="5" creationId="{841BC414-74E4-2FA5-C99C-142E2E825EA5}"/>
          </ac:picMkLst>
        </pc:picChg>
        <pc:picChg chg="add mod">
          <ac:chgData name="Héctor Cañeque Rufo" userId="6da3b7e2-2289-4c25-b14d-207ec07af19d" providerId="ADAL" clId="{928657C9-AE4A-4530-B9C4-A0CC3C8F8204}" dt="2024-01-28T12:44:37.395" v="74" actId="164"/>
          <ac:picMkLst>
            <pc:docMk/>
            <pc:sldMk cId="142087482" sldId="256"/>
            <ac:picMk id="6" creationId="{F5E7708C-4DD6-574D-E0C4-641698764E9B}"/>
          </ac:picMkLst>
        </pc:picChg>
        <pc:picChg chg="add mod">
          <ac:chgData name="Héctor Cañeque Rufo" userId="6da3b7e2-2289-4c25-b14d-207ec07af19d" providerId="ADAL" clId="{928657C9-AE4A-4530-B9C4-A0CC3C8F8204}" dt="2024-01-28T12:44:37.395" v="74" actId="164"/>
          <ac:picMkLst>
            <pc:docMk/>
            <pc:sldMk cId="142087482" sldId="256"/>
            <ac:picMk id="7" creationId="{8DF6CE88-8AD9-A698-764E-099EAD76F157}"/>
          </ac:picMkLst>
        </pc:picChg>
        <pc:picChg chg="add del mod">
          <ac:chgData name="Héctor Cañeque Rufo" userId="6da3b7e2-2289-4c25-b14d-207ec07af19d" providerId="ADAL" clId="{928657C9-AE4A-4530-B9C4-A0CC3C8F8204}" dt="2024-01-30T15:18:14.736" v="927" actId="478"/>
          <ac:picMkLst>
            <pc:docMk/>
            <pc:sldMk cId="142087482" sldId="256"/>
            <ac:picMk id="9" creationId="{7B4E0D46-2044-4593-502B-E03D83987877}"/>
          </ac:picMkLst>
        </pc:picChg>
        <pc:picChg chg="add mod">
          <ac:chgData name="Héctor Cañeque Rufo" userId="6da3b7e2-2289-4c25-b14d-207ec07af19d" providerId="ADAL" clId="{928657C9-AE4A-4530-B9C4-A0CC3C8F8204}" dt="2024-01-29T11:51:47.822" v="690" actId="1036"/>
          <ac:picMkLst>
            <pc:docMk/>
            <pc:sldMk cId="142087482" sldId="256"/>
            <ac:picMk id="10" creationId="{2CC8152F-C344-AA1B-CB40-023C86D4DC28}"/>
          </ac:picMkLst>
        </pc:picChg>
        <pc:picChg chg="add mod">
          <ac:chgData name="Héctor Cañeque Rufo" userId="6da3b7e2-2289-4c25-b14d-207ec07af19d" providerId="ADAL" clId="{928657C9-AE4A-4530-B9C4-A0CC3C8F8204}" dt="2024-01-29T11:51:47.822" v="690" actId="1036"/>
          <ac:picMkLst>
            <pc:docMk/>
            <pc:sldMk cId="142087482" sldId="256"/>
            <ac:picMk id="12" creationId="{D86D94EA-A12C-9981-802E-B2A2F069A561}"/>
          </ac:picMkLst>
        </pc:picChg>
        <pc:picChg chg="add mod">
          <ac:chgData name="Héctor Cañeque Rufo" userId="6da3b7e2-2289-4c25-b14d-207ec07af19d" providerId="ADAL" clId="{928657C9-AE4A-4530-B9C4-A0CC3C8F8204}" dt="2024-01-29T11:51:47.822" v="690" actId="1036"/>
          <ac:picMkLst>
            <pc:docMk/>
            <pc:sldMk cId="142087482" sldId="256"/>
            <ac:picMk id="14" creationId="{9106E4EB-59A6-7242-95BC-B06349CC5925}"/>
          </ac:picMkLst>
        </pc:picChg>
        <pc:picChg chg="add mod ord">
          <ac:chgData name="Héctor Cañeque Rufo" userId="6da3b7e2-2289-4c25-b14d-207ec07af19d" providerId="ADAL" clId="{928657C9-AE4A-4530-B9C4-A0CC3C8F8204}" dt="2024-01-30T15:29:28.431" v="1972" actId="164"/>
          <ac:picMkLst>
            <pc:docMk/>
            <pc:sldMk cId="142087482" sldId="256"/>
            <ac:picMk id="22" creationId="{775A53FD-6EE0-FB95-4C94-4B6DFBFF051A}"/>
          </ac:picMkLst>
        </pc:picChg>
        <pc:picChg chg="add mod ord">
          <ac:chgData name="Héctor Cañeque Rufo" userId="6da3b7e2-2289-4c25-b14d-207ec07af19d" providerId="ADAL" clId="{928657C9-AE4A-4530-B9C4-A0CC3C8F8204}" dt="2024-01-30T15:30:34.285" v="2030" actId="1036"/>
          <ac:picMkLst>
            <pc:docMk/>
            <pc:sldMk cId="142087482" sldId="256"/>
            <ac:picMk id="29" creationId="{83DE1B8E-C055-E29F-EB9B-88C580321E1E}"/>
          </ac:picMkLst>
        </pc:picChg>
      </pc:sldChg>
    </pc:docChg>
  </pc:docChgLst>
  <pc:docChgLst>
    <pc:chgData name="Héctor Cañeque Rufo" userId="6da3b7e2-2289-4c25-b14d-207ec07af19d" providerId="ADAL" clId="{C76670F0-0401-4CB8-A150-171B44285483}"/>
    <pc:docChg chg="modSld">
      <pc:chgData name="Héctor Cañeque Rufo" userId="6da3b7e2-2289-4c25-b14d-207ec07af19d" providerId="ADAL" clId="{C76670F0-0401-4CB8-A150-171B44285483}" dt="2024-02-26T17:48:58.266" v="29" actId="20577"/>
      <pc:docMkLst>
        <pc:docMk/>
      </pc:docMkLst>
      <pc:sldChg chg="modSp mod">
        <pc:chgData name="Héctor Cañeque Rufo" userId="6da3b7e2-2289-4c25-b14d-207ec07af19d" providerId="ADAL" clId="{C76670F0-0401-4CB8-A150-171B44285483}" dt="2024-02-26T17:48:58.266" v="29" actId="20577"/>
        <pc:sldMkLst>
          <pc:docMk/>
          <pc:sldMk cId="3085553057" sldId="257"/>
        </pc:sldMkLst>
        <pc:spChg chg="mod">
          <ac:chgData name="Héctor Cañeque Rufo" userId="6da3b7e2-2289-4c25-b14d-207ec07af19d" providerId="ADAL" clId="{C76670F0-0401-4CB8-A150-171B44285483}" dt="2024-02-26T17:48:58.266" v="29" actId="20577"/>
          <ac:spMkLst>
            <pc:docMk/>
            <pc:sldMk cId="3085553057" sldId="257"/>
            <ac:spMk id="7" creationId="{676DF68A-1B6D-3676-D8EB-1E062061C947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A67EDFE-EDB5-41D8-8DE7-1E798BAC9C9D}" type="datetimeFigureOut">
              <a:rPr lang="es-ES" smtClean="0"/>
              <a:t>18/04/2024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8D1E51A-EBC2-4D9D-93AF-D861281664D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382799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8D1E51A-EBC2-4D9D-93AF-D861281664DE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1492050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E28A058-320C-5C70-9C82-A431AA0B6A5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>
            <a:extLst>
              <a:ext uri="{FF2B5EF4-FFF2-40B4-BE49-F238E27FC236}">
                <a16:creationId xmlns:a16="http://schemas.microsoft.com/office/drawing/2014/main" id="{7B240103-DE77-4A76-890A-C4D2551869F8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>
            <a:extLst>
              <a:ext uri="{FF2B5EF4-FFF2-40B4-BE49-F238E27FC236}">
                <a16:creationId xmlns:a16="http://schemas.microsoft.com/office/drawing/2014/main" id="{972CB90F-F65C-C267-7057-9DC28F723A50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777E6E16-4A7D-CA6F-F170-1370B66CC513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8D1E51A-EBC2-4D9D-93AF-D861281664DE}" type="slidenum">
              <a:rPr lang="es-ES" smtClean="0"/>
              <a:t>2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5590622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2B84B-BE2D-4445-A59B-741875951D58}" type="datetimeFigureOut">
              <a:rPr lang="es-ES" smtClean="0"/>
              <a:t>18/04/2024</a:t>
            </a:fld>
            <a:endParaRPr lang="es-E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6651A6-197F-42F4-9ACC-A1A1B414B87A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8303918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2B84B-BE2D-4445-A59B-741875951D58}" type="datetimeFigureOut">
              <a:rPr lang="es-ES" smtClean="0"/>
              <a:t>18/04/2024</a:t>
            </a:fld>
            <a:endParaRPr lang="es-E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6651A6-197F-42F4-9ACC-A1A1B414B87A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41735065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2B84B-BE2D-4445-A59B-741875951D58}" type="datetimeFigureOut">
              <a:rPr lang="es-ES" smtClean="0"/>
              <a:t>18/04/2024</a:t>
            </a:fld>
            <a:endParaRPr lang="es-E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6651A6-197F-42F4-9ACC-A1A1B414B87A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34637541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2B84B-BE2D-4445-A59B-741875951D58}" type="datetimeFigureOut">
              <a:rPr lang="es-ES" smtClean="0"/>
              <a:t>18/04/2024</a:t>
            </a:fld>
            <a:endParaRPr lang="es-E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6651A6-197F-42F4-9ACC-A1A1B414B87A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37269685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2B84B-BE2D-4445-A59B-741875951D58}" type="datetimeFigureOut">
              <a:rPr lang="es-ES" smtClean="0"/>
              <a:t>18/04/2024</a:t>
            </a:fld>
            <a:endParaRPr lang="es-E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6651A6-197F-42F4-9ACC-A1A1B414B87A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40211783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2B84B-BE2D-4445-A59B-741875951D58}" type="datetimeFigureOut">
              <a:rPr lang="es-ES" smtClean="0"/>
              <a:t>18/04/2024</a:t>
            </a:fld>
            <a:endParaRPr lang="es-E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6651A6-197F-42F4-9ACC-A1A1B414B87A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10330590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2B84B-BE2D-4445-A59B-741875951D58}" type="datetimeFigureOut">
              <a:rPr lang="es-ES" smtClean="0"/>
              <a:t>18/04/2024</a:t>
            </a:fld>
            <a:endParaRPr lang="es-E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6651A6-197F-42F4-9ACC-A1A1B414B87A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21753150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2B84B-BE2D-4445-A59B-741875951D58}" type="datetimeFigureOut">
              <a:rPr lang="es-ES" smtClean="0"/>
              <a:t>18/04/2024</a:t>
            </a:fld>
            <a:endParaRPr lang="es-E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6651A6-197F-42F4-9ACC-A1A1B414B87A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3459862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2B84B-BE2D-4445-A59B-741875951D58}" type="datetimeFigureOut">
              <a:rPr lang="es-ES" smtClean="0"/>
              <a:t>18/04/2024</a:t>
            </a:fld>
            <a:endParaRPr lang="es-E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6651A6-197F-42F4-9ACC-A1A1B414B87A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36213263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2B84B-BE2D-4445-A59B-741875951D58}" type="datetimeFigureOut">
              <a:rPr lang="es-ES" smtClean="0"/>
              <a:t>18/04/2024</a:t>
            </a:fld>
            <a:endParaRPr lang="es-E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6651A6-197F-42F4-9ACC-A1A1B414B87A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28069883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 dirty="0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2B84B-BE2D-4445-A59B-741875951D58}" type="datetimeFigureOut">
              <a:rPr lang="es-ES" smtClean="0"/>
              <a:t>18/04/2024</a:t>
            </a:fld>
            <a:endParaRPr lang="es-E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6651A6-197F-42F4-9ACC-A1A1B414B87A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24807839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D2B84B-BE2D-4445-A59B-741875951D58}" type="datetimeFigureOut">
              <a:rPr lang="es-ES" smtClean="0"/>
              <a:t>18/04/2024</a:t>
            </a:fld>
            <a:endParaRPr lang="es-E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6651A6-197F-42F4-9ACC-A1A1B414B87A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31573398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>
            <a:extLst>
              <a:ext uri="{FF2B5EF4-FFF2-40B4-BE49-F238E27FC236}">
                <a16:creationId xmlns:a16="http://schemas.microsoft.com/office/drawing/2014/main" id="{33E933C6-A531-8CBD-F1AF-449B7750A88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1037" r="20601"/>
          <a:stretch/>
        </p:blipFill>
        <p:spPr>
          <a:xfrm>
            <a:off x="3218181" y="375936"/>
            <a:ext cx="1894576" cy="2134523"/>
          </a:xfrm>
          <a:prstGeom prst="rect">
            <a:avLst/>
          </a:prstGeom>
        </p:spPr>
      </p:pic>
      <p:grpSp>
        <p:nvGrpSpPr>
          <p:cNvPr id="6" name="Grupo 5">
            <a:extLst>
              <a:ext uri="{FF2B5EF4-FFF2-40B4-BE49-F238E27FC236}">
                <a16:creationId xmlns:a16="http://schemas.microsoft.com/office/drawing/2014/main" id="{8C5DBBD7-55A6-946B-AB2A-264B4B0360F2}"/>
              </a:ext>
            </a:extLst>
          </p:cNvPr>
          <p:cNvGrpSpPr/>
          <p:nvPr/>
        </p:nvGrpSpPr>
        <p:grpSpPr>
          <a:xfrm>
            <a:off x="1528200" y="5459199"/>
            <a:ext cx="3801600" cy="3428615"/>
            <a:chOff x="2415071" y="5459199"/>
            <a:chExt cx="3801600" cy="3428615"/>
          </a:xfrm>
        </p:grpSpPr>
        <p:pic>
          <p:nvPicPr>
            <p:cNvPr id="5" name="Imagen 4">
              <a:extLst>
                <a:ext uri="{FF2B5EF4-FFF2-40B4-BE49-F238E27FC236}">
                  <a16:creationId xmlns:a16="http://schemas.microsoft.com/office/drawing/2014/main" id="{DE240BE7-99FA-FE76-4513-AAC830931EC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415071" y="5687787"/>
              <a:ext cx="3801600" cy="3200027"/>
            </a:xfrm>
            <a:prstGeom prst="rect">
              <a:avLst/>
            </a:prstGeom>
          </p:spPr>
        </p:pic>
        <p:pic>
          <p:nvPicPr>
            <p:cNvPr id="29" name="Imagen 28" descr="Interfaz de usuario gráfica&#10;&#10;Descripción generada automáticamente con confianza media">
              <a:extLst>
                <a:ext uri="{FF2B5EF4-FFF2-40B4-BE49-F238E27FC236}">
                  <a16:creationId xmlns:a16="http://schemas.microsoft.com/office/drawing/2014/main" id="{83DE1B8E-C055-E29F-EB9B-88C580321E1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456" r="12355" b="89176"/>
            <a:stretch/>
          </p:blipFill>
          <p:spPr>
            <a:xfrm>
              <a:off x="3766185" y="5459199"/>
              <a:ext cx="1981200" cy="369802"/>
            </a:xfrm>
            <a:prstGeom prst="rect">
              <a:avLst/>
            </a:prstGeom>
          </p:spPr>
        </p:pic>
      </p:grpSp>
      <p:pic>
        <p:nvPicPr>
          <p:cNvPr id="3" name="Imagen 2">
            <a:extLst>
              <a:ext uri="{FF2B5EF4-FFF2-40B4-BE49-F238E27FC236}">
                <a16:creationId xmlns:a16="http://schemas.microsoft.com/office/drawing/2014/main" id="{AF25BC8C-0FC5-BCE0-B03B-FC28105B1AA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51037"/>
          <a:stretch/>
        </p:blipFill>
        <p:spPr>
          <a:xfrm>
            <a:off x="0" y="375936"/>
            <a:ext cx="3270779" cy="2134524"/>
          </a:xfrm>
          <a:prstGeom prst="rect">
            <a:avLst/>
          </a:prstGeom>
        </p:spPr>
      </p:pic>
      <p:pic>
        <p:nvPicPr>
          <p:cNvPr id="10" name="Imagen 9">
            <a:extLst>
              <a:ext uri="{FF2B5EF4-FFF2-40B4-BE49-F238E27FC236}">
                <a16:creationId xmlns:a16="http://schemas.microsoft.com/office/drawing/2014/main" id="{2CC8152F-C344-AA1B-CB40-023C86D4DC2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0124" y="2867031"/>
            <a:ext cx="3208556" cy="2139036"/>
          </a:xfrm>
          <a:prstGeom prst="rect">
            <a:avLst/>
          </a:prstGeom>
        </p:spPr>
      </p:pic>
      <p:pic>
        <p:nvPicPr>
          <p:cNvPr id="14" name="Imagen 13">
            <a:extLst>
              <a:ext uri="{FF2B5EF4-FFF2-40B4-BE49-F238E27FC236}">
                <a16:creationId xmlns:a16="http://schemas.microsoft.com/office/drawing/2014/main" id="{9106E4EB-59A6-7242-95BC-B06349CC592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267689" y="2841003"/>
            <a:ext cx="1876041" cy="2166331"/>
          </a:xfrm>
          <a:prstGeom prst="rect">
            <a:avLst/>
          </a:prstGeom>
        </p:spPr>
      </p:pic>
      <p:sp>
        <p:nvSpPr>
          <p:cNvPr id="15" name="CuadroTexto 14">
            <a:extLst>
              <a:ext uri="{FF2B5EF4-FFF2-40B4-BE49-F238E27FC236}">
                <a16:creationId xmlns:a16="http://schemas.microsoft.com/office/drawing/2014/main" id="{5B61CCD1-ABF1-D32F-6BAE-FA70EE4AC2D7}"/>
              </a:ext>
            </a:extLst>
          </p:cNvPr>
          <p:cNvSpPr txBox="1"/>
          <p:nvPr/>
        </p:nvSpPr>
        <p:spPr>
          <a:xfrm>
            <a:off x="3194584" y="184555"/>
            <a:ext cx="91242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Biosamples_id</a:t>
            </a:r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id="{3669DA83-2DEC-0E63-6B35-9E93EB249398}"/>
              </a:ext>
            </a:extLst>
          </p:cNvPr>
          <p:cNvSpPr txBox="1"/>
          <p:nvPr/>
        </p:nvSpPr>
        <p:spPr>
          <a:xfrm>
            <a:off x="3194584" y="2663595"/>
            <a:ext cx="61427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Cell type</a:t>
            </a:r>
          </a:p>
        </p:txBody>
      </p:sp>
      <p:sp>
        <p:nvSpPr>
          <p:cNvPr id="4" name="Rectángulo 3">
            <a:extLst>
              <a:ext uri="{FF2B5EF4-FFF2-40B4-BE49-F238E27FC236}">
                <a16:creationId xmlns:a16="http://schemas.microsoft.com/office/drawing/2014/main" id="{88067669-76CB-0D5B-023E-283311E9A6F0}"/>
              </a:ext>
            </a:extLst>
          </p:cNvPr>
          <p:cNvSpPr/>
          <p:nvPr/>
        </p:nvSpPr>
        <p:spPr>
          <a:xfrm>
            <a:off x="5177512" y="698189"/>
            <a:ext cx="153011" cy="153011"/>
          </a:xfrm>
          <a:prstGeom prst="rect">
            <a:avLst/>
          </a:prstGeom>
          <a:solidFill>
            <a:srgbClr val="E41A1C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9" name="Rectángulo 8">
            <a:extLst>
              <a:ext uri="{FF2B5EF4-FFF2-40B4-BE49-F238E27FC236}">
                <a16:creationId xmlns:a16="http://schemas.microsoft.com/office/drawing/2014/main" id="{10B7A6CE-501F-E30A-E8B7-BDD9716D2D4A}"/>
              </a:ext>
            </a:extLst>
          </p:cNvPr>
          <p:cNvSpPr/>
          <p:nvPr/>
        </p:nvSpPr>
        <p:spPr>
          <a:xfrm>
            <a:off x="5177512" y="881069"/>
            <a:ext cx="153011" cy="153011"/>
          </a:xfrm>
          <a:prstGeom prst="rect">
            <a:avLst/>
          </a:prstGeom>
          <a:solidFill>
            <a:srgbClr val="377EB8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1" name="Rectángulo 10">
            <a:extLst>
              <a:ext uri="{FF2B5EF4-FFF2-40B4-BE49-F238E27FC236}">
                <a16:creationId xmlns:a16="http://schemas.microsoft.com/office/drawing/2014/main" id="{16A617D2-9461-18E2-8750-84DF3CACDCF2}"/>
              </a:ext>
            </a:extLst>
          </p:cNvPr>
          <p:cNvSpPr/>
          <p:nvPr/>
        </p:nvSpPr>
        <p:spPr>
          <a:xfrm>
            <a:off x="5177512" y="1063949"/>
            <a:ext cx="153011" cy="153011"/>
          </a:xfrm>
          <a:prstGeom prst="rect">
            <a:avLst/>
          </a:prstGeom>
          <a:solidFill>
            <a:srgbClr val="FF7F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3" name="Rectángulo 12">
            <a:extLst>
              <a:ext uri="{FF2B5EF4-FFF2-40B4-BE49-F238E27FC236}">
                <a16:creationId xmlns:a16="http://schemas.microsoft.com/office/drawing/2014/main" id="{5E8EF11B-2D00-5A61-BAF7-31EC7E03D2BA}"/>
              </a:ext>
            </a:extLst>
          </p:cNvPr>
          <p:cNvSpPr/>
          <p:nvPr/>
        </p:nvSpPr>
        <p:spPr>
          <a:xfrm>
            <a:off x="5177512" y="1251909"/>
            <a:ext cx="153011" cy="153011"/>
          </a:xfrm>
          <a:prstGeom prst="rect">
            <a:avLst/>
          </a:prstGeom>
          <a:solidFill>
            <a:srgbClr val="A65628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7" name="Rectángulo 16">
            <a:extLst>
              <a:ext uri="{FF2B5EF4-FFF2-40B4-BE49-F238E27FC236}">
                <a16:creationId xmlns:a16="http://schemas.microsoft.com/office/drawing/2014/main" id="{D76BE7A9-B512-11FD-3675-C94CF6F87D66}"/>
              </a:ext>
            </a:extLst>
          </p:cNvPr>
          <p:cNvSpPr/>
          <p:nvPr/>
        </p:nvSpPr>
        <p:spPr>
          <a:xfrm>
            <a:off x="5177512" y="1734509"/>
            <a:ext cx="153011" cy="153011"/>
          </a:xfrm>
          <a:prstGeom prst="rect">
            <a:avLst/>
          </a:prstGeom>
          <a:solidFill>
            <a:srgbClr val="E41A1C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8" name="Rectángulo 17">
            <a:extLst>
              <a:ext uri="{FF2B5EF4-FFF2-40B4-BE49-F238E27FC236}">
                <a16:creationId xmlns:a16="http://schemas.microsoft.com/office/drawing/2014/main" id="{11243C6C-66FB-7BC5-DEDB-6BBBF85ACF9A}"/>
              </a:ext>
            </a:extLst>
          </p:cNvPr>
          <p:cNvSpPr/>
          <p:nvPr/>
        </p:nvSpPr>
        <p:spPr>
          <a:xfrm>
            <a:off x="5177512" y="1917389"/>
            <a:ext cx="153011" cy="153011"/>
          </a:xfrm>
          <a:prstGeom prst="rect">
            <a:avLst/>
          </a:prstGeom>
          <a:solidFill>
            <a:srgbClr val="377EB8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9" name="Rectángulo 18">
            <a:extLst>
              <a:ext uri="{FF2B5EF4-FFF2-40B4-BE49-F238E27FC236}">
                <a16:creationId xmlns:a16="http://schemas.microsoft.com/office/drawing/2014/main" id="{F5B81CC3-A9AA-CC7C-68C7-502B6723D4C9}"/>
              </a:ext>
            </a:extLst>
          </p:cNvPr>
          <p:cNvSpPr/>
          <p:nvPr/>
        </p:nvSpPr>
        <p:spPr>
          <a:xfrm>
            <a:off x="5177512" y="2100269"/>
            <a:ext cx="153011" cy="153011"/>
          </a:xfrm>
          <a:prstGeom prst="rect">
            <a:avLst/>
          </a:prstGeom>
          <a:solidFill>
            <a:srgbClr val="4DAF4A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20" name="Rectángulo 19">
            <a:extLst>
              <a:ext uri="{FF2B5EF4-FFF2-40B4-BE49-F238E27FC236}">
                <a16:creationId xmlns:a16="http://schemas.microsoft.com/office/drawing/2014/main" id="{5C52686D-587B-05E2-379B-0287C8A9DE2A}"/>
              </a:ext>
            </a:extLst>
          </p:cNvPr>
          <p:cNvSpPr/>
          <p:nvPr/>
        </p:nvSpPr>
        <p:spPr>
          <a:xfrm>
            <a:off x="5177512" y="2278069"/>
            <a:ext cx="153011" cy="153011"/>
          </a:xfrm>
          <a:prstGeom prst="rect">
            <a:avLst/>
          </a:prstGeom>
          <a:solidFill>
            <a:srgbClr val="984EA3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21" name="Rectángulo 20">
            <a:extLst>
              <a:ext uri="{FF2B5EF4-FFF2-40B4-BE49-F238E27FC236}">
                <a16:creationId xmlns:a16="http://schemas.microsoft.com/office/drawing/2014/main" id="{A0EAFA40-F17B-A680-2505-DD0858E97083}"/>
              </a:ext>
            </a:extLst>
          </p:cNvPr>
          <p:cNvSpPr/>
          <p:nvPr/>
        </p:nvSpPr>
        <p:spPr>
          <a:xfrm>
            <a:off x="5177512" y="2466029"/>
            <a:ext cx="153011" cy="153011"/>
          </a:xfrm>
          <a:prstGeom prst="rect">
            <a:avLst/>
          </a:prstGeom>
          <a:solidFill>
            <a:srgbClr val="FF7F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22" name="Rectángulo 21">
            <a:extLst>
              <a:ext uri="{FF2B5EF4-FFF2-40B4-BE49-F238E27FC236}">
                <a16:creationId xmlns:a16="http://schemas.microsoft.com/office/drawing/2014/main" id="{28CD644B-5F8F-A2A1-36FB-9F610247C52A}"/>
              </a:ext>
            </a:extLst>
          </p:cNvPr>
          <p:cNvSpPr/>
          <p:nvPr/>
        </p:nvSpPr>
        <p:spPr>
          <a:xfrm>
            <a:off x="5177512" y="2648909"/>
            <a:ext cx="153011" cy="153011"/>
          </a:xfrm>
          <a:prstGeom prst="rect">
            <a:avLst/>
          </a:prstGeom>
          <a:solidFill>
            <a:srgbClr val="A65628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23" name="Rectángulo 22">
            <a:extLst>
              <a:ext uri="{FF2B5EF4-FFF2-40B4-BE49-F238E27FC236}">
                <a16:creationId xmlns:a16="http://schemas.microsoft.com/office/drawing/2014/main" id="{88DE1504-44FC-2EE7-A3C1-0F600720C6FF}"/>
              </a:ext>
            </a:extLst>
          </p:cNvPr>
          <p:cNvSpPr/>
          <p:nvPr/>
        </p:nvSpPr>
        <p:spPr>
          <a:xfrm>
            <a:off x="5177512" y="2831789"/>
            <a:ext cx="153011" cy="153011"/>
          </a:xfrm>
          <a:prstGeom prst="rect">
            <a:avLst/>
          </a:prstGeom>
          <a:solidFill>
            <a:srgbClr val="F781BF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24" name="Rectángulo 23">
            <a:extLst>
              <a:ext uri="{FF2B5EF4-FFF2-40B4-BE49-F238E27FC236}">
                <a16:creationId xmlns:a16="http://schemas.microsoft.com/office/drawing/2014/main" id="{0169A0E0-F81E-4A83-0F98-5FFCEDE9628C}"/>
              </a:ext>
            </a:extLst>
          </p:cNvPr>
          <p:cNvSpPr/>
          <p:nvPr/>
        </p:nvSpPr>
        <p:spPr>
          <a:xfrm>
            <a:off x="5177512" y="3009589"/>
            <a:ext cx="153011" cy="153011"/>
          </a:xfrm>
          <a:prstGeom prst="rect">
            <a:avLst/>
          </a:prstGeom>
          <a:solidFill>
            <a:srgbClr val="99999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25" name="Rectángulo 24">
            <a:extLst>
              <a:ext uri="{FF2B5EF4-FFF2-40B4-BE49-F238E27FC236}">
                <a16:creationId xmlns:a16="http://schemas.microsoft.com/office/drawing/2014/main" id="{EEE284C9-DB97-6E34-6423-7E77F594A46B}"/>
              </a:ext>
            </a:extLst>
          </p:cNvPr>
          <p:cNvSpPr/>
          <p:nvPr/>
        </p:nvSpPr>
        <p:spPr>
          <a:xfrm>
            <a:off x="5177512" y="3192469"/>
            <a:ext cx="153011" cy="153011"/>
          </a:xfrm>
          <a:prstGeom prst="rect">
            <a:avLst/>
          </a:prstGeom>
          <a:solidFill>
            <a:srgbClr val="66C2A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26" name="Rectángulo 25">
            <a:extLst>
              <a:ext uri="{FF2B5EF4-FFF2-40B4-BE49-F238E27FC236}">
                <a16:creationId xmlns:a16="http://schemas.microsoft.com/office/drawing/2014/main" id="{56787995-2D3C-B661-8050-A0FFC6741DCF}"/>
              </a:ext>
            </a:extLst>
          </p:cNvPr>
          <p:cNvSpPr/>
          <p:nvPr/>
        </p:nvSpPr>
        <p:spPr>
          <a:xfrm>
            <a:off x="5177512" y="3375349"/>
            <a:ext cx="153011" cy="153011"/>
          </a:xfrm>
          <a:prstGeom prst="rect">
            <a:avLst/>
          </a:prstGeom>
          <a:solidFill>
            <a:srgbClr val="FC8D62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27" name="Rectángulo 26">
            <a:extLst>
              <a:ext uri="{FF2B5EF4-FFF2-40B4-BE49-F238E27FC236}">
                <a16:creationId xmlns:a16="http://schemas.microsoft.com/office/drawing/2014/main" id="{8F0230BC-F4FF-6F02-7E67-2D689E50FFE6}"/>
              </a:ext>
            </a:extLst>
          </p:cNvPr>
          <p:cNvSpPr/>
          <p:nvPr/>
        </p:nvSpPr>
        <p:spPr>
          <a:xfrm>
            <a:off x="5177512" y="3558229"/>
            <a:ext cx="153011" cy="153011"/>
          </a:xfrm>
          <a:prstGeom prst="rect">
            <a:avLst/>
          </a:prstGeom>
          <a:solidFill>
            <a:srgbClr val="8DA0CB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28" name="Rectángulo 27">
            <a:extLst>
              <a:ext uri="{FF2B5EF4-FFF2-40B4-BE49-F238E27FC236}">
                <a16:creationId xmlns:a16="http://schemas.microsoft.com/office/drawing/2014/main" id="{67AEFD57-41E2-8BD9-4591-B7065CED7D90}"/>
              </a:ext>
            </a:extLst>
          </p:cNvPr>
          <p:cNvSpPr/>
          <p:nvPr/>
        </p:nvSpPr>
        <p:spPr>
          <a:xfrm>
            <a:off x="5177512" y="3741109"/>
            <a:ext cx="153011" cy="153011"/>
          </a:xfrm>
          <a:prstGeom prst="rect">
            <a:avLst/>
          </a:prstGeom>
          <a:solidFill>
            <a:srgbClr val="E78AC3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30" name="Rectángulo 29">
            <a:extLst>
              <a:ext uri="{FF2B5EF4-FFF2-40B4-BE49-F238E27FC236}">
                <a16:creationId xmlns:a16="http://schemas.microsoft.com/office/drawing/2014/main" id="{28DC1A67-62C3-C655-8D47-1F8797B507C5}"/>
              </a:ext>
            </a:extLst>
          </p:cNvPr>
          <p:cNvSpPr/>
          <p:nvPr/>
        </p:nvSpPr>
        <p:spPr>
          <a:xfrm>
            <a:off x="5177512" y="3923989"/>
            <a:ext cx="153011" cy="153011"/>
          </a:xfrm>
          <a:prstGeom prst="rect">
            <a:avLst/>
          </a:prstGeom>
          <a:solidFill>
            <a:srgbClr val="A6D854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31" name="Rectángulo 30">
            <a:extLst>
              <a:ext uri="{FF2B5EF4-FFF2-40B4-BE49-F238E27FC236}">
                <a16:creationId xmlns:a16="http://schemas.microsoft.com/office/drawing/2014/main" id="{880E8D9A-AEEC-5F66-D713-E721D14868B3}"/>
              </a:ext>
            </a:extLst>
          </p:cNvPr>
          <p:cNvSpPr/>
          <p:nvPr/>
        </p:nvSpPr>
        <p:spPr>
          <a:xfrm>
            <a:off x="5177512" y="4101789"/>
            <a:ext cx="153011" cy="153011"/>
          </a:xfrm>
          <a:prstGeom prst="rect">
            <a:avLst/>
          </a:prstGeom>
          <a:solidFill>
            <a:srgbClr val="FFD92F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32" name="Rectángulo 31">
            <a:extLst>
              <a:ext uri="{FF2B5EF4-FFF2-40B4-BE49-F238E27FC236}">
                <a16:creationId xmlns:a16="http://schemas.microsoft.com/office/drawing/2014/main" id="{E554D646-3EA6-0964-D9AC-960627CAE6E6}"/>
              </a:ext>
            </a:extLst>
          </p:cNvPr>
          <p:cNvSpPr/>
          <p:nvPr/>
        </p:nvSpPr>
        <p:spPr>
          <a:xfrm>
            <a:off x="5177512" y="4289749"/>
            <a:ext cx="153011" cy="153011"/>
          </a:xfrm>
          <a:prstGeom prst="rect">
            <a:avLst/>
          </a:prstGeom>
          <a:solidFill>
            <a:srgbClr val="E5C494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33" name="Rectángulo 32">
            <a:extLst>
              <a:ext uri="{FF2B5EF4-FFF2-40B4-BE49-F238E27FC236}">
                <a16:creationId xmlns:a16="http://schemas.microsoft.com/office/drawing/2014/main" id="{814BABDD-CE46-E35B-3C30-1B226946B9E4}"/>
              </a:ext>
            </a:extLst>
          </p:cNvPr>
          <p:cNvSpPr/>
          <p:nvPr/>
        </p:nvSpPr>
        <p:spPr>
          <a:xfrm>
            <a:off x="5177512" y="4467549"/>
            <a:ext cx="153011" cy="153011"/>
          </a:xfrm>
          <a:prstGeom prst="rect">
            <a:avLst/>
          </a:prstGeom>
          <a:solidFill>
            <a:srgbClr val="B3B3B3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34" name="Rectángulo 33">
            <a:extLst>
              <a:ext uri="{FF2B5EF4-FFF2-40B4-BE49-F238E27FC236}">
                <a16:creationId xmlns:a16="http://schemas.microsoft.com/office/drawing/2014/main" id="{5B028912-63E7-7C3C-1230-3F50F56517D7}"/>
              </a:ext>
            </a:extLst>
          </p:cNvPr>
          <p:cNvSpPr/>
          <p:nvPr/>
        </p:nvSpPr>
        <p:spPr>
          <a:xfrm>
            <a:off x="5177512" y="4655509"/>
            <a:ext cx="153011" cy="153011"/>
          </a:xfrm>
          <a:prstGeom prst="rect">
            <a:avLst/>
          </a:prstGeom>
          <a:solidFill>
            <a:srgbClr val="8DD3C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35" name="Rectángulo 34">
            <a:extLst>
              <a:ext uri="{FF2B5EF4-FFF2-40B4-BE49-F238E27FC236}">
                <a16:creationId xmlns:a16="http://schemas.microsoft.com/office/drawing/2014/main" id="{BF1C3909-A22E-8F89-0001-1B4489C22476}"/>
              </a:ext>
            </a:extLst>
          </p:cNvPr>
          <p:cNvSpPr/>
          <p:nvPr/>
        </p:nvSpPr>
        <p:spPr>
          <a:xfrm>
            <a:off x="5177512" y="4833309"/>
            <a:ext cx="153011" cy="153011"/>
          </a:xfrm>
          <a:prstGeom prst="rect">
            <a:avLst/>
          </a:prstGeom>
          <a:solidFill>
            <a:srgbClr val="BEBADA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36" name="CuadroTexto 35">
            <a:extLst>
              <a:ext uri="{FF2B5EF4-FFF2-40B4-BE49-F238E27FC236}">
                <a16:creationId xmlns:a16="http://schemas.microsoft.com/office/drawing/2014/main" id="{73FBAC0F-973B-42C9-84AF-E08A66C9001B}"/>
              </a:ext>
            </a:extLst>
          </p:cNvPr>
          <p:cNvSpPr txBox="1"/>
          <p:nvPr/>
        </p:nvSpPr>
        <p:spPr>
          <a:xfrm>
            <a:off x="5093567" y="485168"/>
            <a:ext cx="91242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Biosamples_id</a:t>
            </a:r>
          </a:p>
        </p:txBody>
      </p:sp>
      <p:sp>
        <p:nvSpPr>
          <p:cNvPr id="37" name="CuadroTexto 36">
            <a:extLst>
              <a:ext uri="{FF2B5EF4-FFF2-40B4-BE49-F238E27FC236}">
                <a16:creationId xmlns:a16="http://schemas.microsoft.com/office/drawing/2014/main" id="{503C1B7C-2EED-C2EB-266B-331EA7D29164}"/>
              </a:ext>
            </a:extLst>
          </p:cNvPr>
          <p:cNvSpPr txBox="1"/>
          <p:nvPr/>
        </p:nvSpPr>
        <p:spPr>
          <a:xfrm>
            <a:off x="5277814" y="662968"/>
            <a:ext cx="5052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STD_1</a:t>
            </a:r>
          </a:p>
        </p:txBody>
      </p:sp>
      <p:sp>
        <p:nvSpPr>
          <p:cNvPr id="38" name="CuadroTexto 37">
            <a:extLst>
              <a:ext uri="{FF2B5EF4-FFF2-40B4-BE49-F238E27FC236}">
                <a16:creationId xmlns:a16="http://schemas.microsoft.com/office/drawing/2014/main" id="{CD70A6C3-4362-11F3-D29F-BDCC6EA9DA71}"/>
              </a:ext>
            </a:extLst>
          </p:cNvPr>
          <p:cNvSpPr txBox="1"/>
          <p:nvPr/>
        </p:nvSpPr>
        <p:spPr>
          <a:xfrm>
            <a:off x="5280218" y="845848"/>
            <a:ext cx="5052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STD_2</a:t>
            </a:r>
          </a:p>
        </p:txBody>
      </p:sp>
      <p:sp>
        <p:nvSpPr>
          <p:cNvPr id="39" name="CuadroTexto 38">
            <a:extLst>
              <a:ext uri="{FF2B5EF4-FFF2-40B4-BE49-F238E27FC236}">
                <a16:creationId xmlns:a16="http://schemas.microsoft.com/office/drawing/2014/main" id="{BE0DD912-C19B-B368-D7C9-04C53F1D5C7C}"/>
              </a:ext>
            </a:extLst>
          </p:cNvPr>
          <p:cNvSpPr txBox="1"/>
          <p:nvPr/>
        </p:nvSpPr>
        <p:spPr>
          <a:xfrm>
            <a:off x="5273005" y="1034181"/>
            <a:ext cx="51007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HFD_1</a:t>
            </a:r>
          </a:p>
        </p:txBody>
      </p:sp>
      <p:sp>
        <p:nvSpPr>
          <p:cNvPr id="40" name="CuadroTexto 39">
            <a:extLst>
              <a:ext uri="{FF2B5EF4-FFF2-40B4-BE49-F238E27FC236}">
                <a16:creationId xmlns:a16="http://schemas.microsoft.com/office/drawing/2014/main" id="{48C60739-F142-7ACE-13D9-DC5D9926A1C3}"/>
              </a:ext>
            </a:extLst>
          </p:cNvPr>
          <p:cNvSpPr txBox="1"/>
          <p:nvPr/>
        </p:nvSpPr>
        <p:spPr>
          <a:xfrm>
            <a:off x="5273005" y="1217061"/>
            <a:ext cx="51007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HFD_2</a:t>
            </a:r>
          </a:p>
        </p:txBody>
      </p:sp>
      <p:sp>
        <p:nvSpPr>
          <p:cNvPr id="44" name="CuadroTexto 43">
            <a:extLst>
              <a:ext uri="{FF2B5EF4-FFF2-40B4-BE49-F238E27FC236}">
                <a16:creationId xmlns:a16="http://schemas.microsoft.com/office/drawing/2014/main" id="{3808C2CA-69A2-7028-3BB4-CF8E509230D9}"/>
              </a:ext>
            </a:extLst>
          </p:cNvPr>
          <p:cNvSpPr txBox="1"/>
          <p:nvPr/>
        </p:nvSpPr>
        <p:spPr>
          <a:xfrm>
            <a:off x="5289883" y="1657413"/>
            <a:ext cx="1610360" cy="339349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Astrocytes</a:t>
            </a:r>
          </a:p>
          <a:p>
            <a:pPr>
              <a:lnSpc>
                <a:spcPct val="150000"/>
              </a:lnSpc>
            </a:pP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ndothelial cells</a:t>
            </a:r>
          </a:p>
          <a:p>
            <a:pPr>
              <a:lnSpc>
                <a:spcPct val="150000"/>
              </a:lnSpc>
            </a:pP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pendymal cells</a:t>
            </a:r>
          </a:p>
          <a:p>
            <a:pPr>
              <a:lnSpc>
                <a:spcPct val="150000"/>
              </a:lnSpc>
            </a:pP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GABAergic neurons</a:t>
            </a:r>
          </a:p>
          <a:p>
            <a:pPr>
              <a:lnSpc>
                <a:spcPct val="150000"/>
              </a:lnSpc>
            </a:pP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General neurons</a:t>
            </a:r>
          </a:p>
          <a:p>
            <a:pPr>
              <a:lnSpc>
                <a:spcPct val="150000"/>
              </a:lnSpc>
            </a:pP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Glutamatergic neurons</a:t>
            </a:r>
          </a:p>
          <a:p>
            <a:pPr>
              <a:lnSpc>
                <a:spcPct val="150000"/>
              </a:lnSpc>
            </a:pP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Macrophages</a:t>
            </a:r>
          </a:p>
          <a:p>
            <a:pPr>
              <a:lnSpc>
                <a:spcPct val="150000"/>
              </a:lnSpc>
            </a:pP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Microglial cells</a:t>
            </a:r>
          </a:p>
          <a:p>
            <a:pPr>
              <a:lnSpc>
                <a:spcPct val="150000"/>
              </a:lnSpc>
            </a:pP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Microglial cells_Nfkbiz</a:t>
            </a:r>
          </a:p>
          <a:p>
            <a:pPr>
              <a:lnSpc>
                <a:spcPct val="150000"/>
              </a:lnSpc>
            </a:pP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Muralpericytes_Acta2</a:t>
            </a:r>
          </a:p>
          <a:p>
            <a:pPr>
              <a:lnSpc>
                <a:spcPct val="150000"/>
              </a:lnSpc>
            </a:pP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Myelinating oligodendrocytes</a:t>
            </a:r>
          </a:p>
          <a:p>
            <a:pPr>
              <a:lnSpc>
                <a:spcPct val="150000"/>
              </a:lnSpc>
            </a:pP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ewly formed oligodendrocytes</a:t>
            </a:r>
          </a:p>
          <a:p>
            <a:pPr>
              <a:lnSpc>
                <a:spcPct val="150000"/>
              </a:lnSpc>
            </a:pP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Oligodendrocytes precursor</a:t>
            </a:r>
          </a:p>
          <a:p>
            <a:pPr>
              <a:lnSpc>
                <a:spcPct val="150000"/>
              </a:lnSpc>
            </a:pP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ars tuberalis</a:t>
            </a:r>
          </a:p>
          <a:p>
            <a:pPr>
              <a:lnSpc>
                <a:spcPct val="150000"/>
              </a:lnSpc>
            </a:pP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ericyes_Kcnj8</a:t>
            </a:r>
          </a:p>
          <a:p>
            <a:pPr>
              <a:lnSpc>
                <a:spcPct val="150000"/>
              </a:lnSpc>
            </a:pP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ericytes</a:t>
            </a:r>
          </a:p>
          <a:p>
            <a:pPr>
              <a:lnSpc>
                <a:spcPct val="150000"/>
              </a:lnSpc>
            </a:pP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Tanycytes</a:t>
            </a:r>
          </a:p>
          <a:p>
            <a:pPr>
              <a:lnSpc>
                <a:spcPct val="150000"/>
              </a:lnSpc>
            </a:pP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Vascular Leptomenigeal cells</a:t>
            </a:r>
          </a:p>
        </p:txBody>
      </p:sp>
      <p:sp>
        <p:nvSpPr>
          <p:cNvPr id="45" name="CuadroTexto 44">
            <a:extLst>
              <a:ext uri="{FF2B5EF4-FFF2-40B4-BE49-F238E27FC236}">
                <a16:creationId xmlns:a16="http://schemas.microsoft.com/office/drawing/2014/main" id="{153F091A-41BF-3AC7-3B46-628A8B9DE8B0}"/>
              </a:ext>
            </a:extLst>
          </p:cNvPr>
          <p:cNvSpPr txBox="1"/>
          <p:nvPr/>
        </p:nvSpPr>
        <p:spPr>
          <a:xfrm>
            <a:off x="5085947" y="1513868"/>
            <a:ext cx="61427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Cell type</a:t>
            </a:r>
          </a:p>
        </p:txBody>
      </p:sp>
      <p:sp>
        <p:nvSpPr>
          <p:cNvPr id="46" name="CuadroTexto 45">
            <a:extLst>
              <a:ext uri="{FF2B5EF4-FFF2-40B4-BE49-F238E27FC236}">
                <a16:creationId xmlns:a16="http://schemas.microsoft.com/office/drawing/2014/main" id="{D5EA56CF-350E-57AD-588D-EBB667B688C4}"/>
              </a:ext>
            </a:extLst>
          </p:cNvPr>
          <p:cNvSpPr txBox="1"/>
          <p:nvPr/>
        </p:nvSpPr>
        <p:spPr>
          <a:xfrm>
            <a:off x="0" y="91345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8" name="CuadroTexto 47">
            <a:extLst>
              <a:ext uri="{FF2B5EF4-FFF2-40B4-BE49-F238E27FC236}">
                <a16:creationId xmlns:a16="http://schemas.microsoft.com/office/drawing/2014/main" id="{1D496425-76CA-2A19-2F33-A486884CB010}"/>
              </a:ext>
            </a:extLst>
          </p:cNvPr>
          <p:cNvSpPr txBox="1"/>
          <p:nvPr/>
        </p:nvSpPr>
        <p:spPr>
          <a:xfrm>
            <a:off x="1438657" y="535589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420874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3A54E41-77F1-109A-39E9-F46D70B3D2D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uadro de texto 47">
            <a:extLst>
              <a:ext uri="{FF2B5EF4-FFF2-40B4-BE49-F238E27FC236}">
                <a16:creationId xmlns:a16="http://schemas.microsoft.com/office/drawing/2014/main" id="{676DF68A-1B6D-3676-D8EB-1E062061C94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9000" y="266220"/>
            <a:ext cx="6480000" cy="2409924"/>
          </a:xfrm>
          <a:prstGeom prst="rect">
            <a:avLst/>
          </a:prstGeom>
          <a:noFill/>
          <a:ln>
            <a:noFill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GB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3</a:t>
            </a:r>
            <a:r>
              <a:rPr lang="en-GB" sz="12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</a:t>
            </a:r>
            <a:r>
              <a:rPr lang="en-GB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High-fat diet feeding effects on </a:t>
            </a:r>
            <a:r>
              <a:rPr lang="en-GB" sz="1200" b="1" i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tn</a:t>
            </a:r>
            <a:r>
              <a:rPr lang="en-GB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and </a:t>
            </a:r>
            <a:r>
              <a:rPr lang="en-GB" sz="1200" b="1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tprz1</a:t>
            </a:r>
            <a:r>
              <a:rPr lang="en-GB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differential cell expression. </a:t>
            </a:r>
            <a:r>
              <a:rPr lang="en-GB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ingle-cell analysis of </a:t>
            </a:r>
            <a:r>
              <a:rPr lang="en-GB" sz="1200" i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tn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and </a:t>
            </a:r>
            <a:r>
              <a:rPr lang="en-GB" sz="12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tprz1</a:t>
            </a:r>
            <a:r>
              <a:rPr lang="en-GB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differential expression in mice samples grouped by clustering represented by t-distributed stochastic neighbour embedding (t-SNE) plot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(A)</a:t>
            </a:r>
            <a:r>
              <a:rPr lang="en-GB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;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Heatma</a:t>
            </a:r>
            <a:r>
              <a:rPr lang="en-GB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 of </a:t>
            </a:r>
            <a:r>
              <a:rPr lang="en-GB" sz="1200" i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tn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and </a:t>
            </a:r>
            <a:r>
              <a:rPr lang="en-GB" sz="12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tprz1</a:t>
            </a:r>
            <a:r>
              <a:rPr lang="en-GB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expression in different cell types from 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ice fed with a standard chow diet (STD) or with a high-fat diet (HFD) (n = 8657 cells) (B)</a:t>
            </a:r>
            <a:r>
              <a:rPr lang="en-GB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*</a:t>
            </a:r>
            <a:r>
              <a:rPr lang="en-GB" sz="12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&lt; 0.05, ***</a:t>
            </a:r>
            <a:r>
              <a:rPr lang="en-GB" sz="12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&lt; 0.001. Single-cell data was obtained from the Single Cell Portal published study “</a:t>
            </a:r>
            <a:r>
              <a:rPr lang="en-US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ultitissue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Single-Cell Analysis Reveals Differential Tissue, Cellular, and Molecular Sensitivity Between Fructose and High Fat High Sucrose Diets”.</a:t>
            </a:r>
          </a:p>
        </p:txBody>
      </p:sp>
    </p:spTree>
    <p:extLst>
      <p:ext uri="{BB962C8B-B14F-4D97-AF65-F5344CB8AC3E}">
        <p14:creationId xmlns:p14="http://schemas.microsoft.com/office/powerpoint/2010/main" val="308555305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32</TotalTime>
  <Words>189</Words>
  <Application>Microsoft Office PowerPoint</Application>
  <PresentationFormat>A4 (210 x 297 mm)</PresentationFormat>
  <Paragraphs>31</Paragraphs>
  <Slides>2</Slides>
  <Notes>2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ema de Office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Héctor Cañeque Rufo</dc:creator>
  <cp:lastModifiedBy>Héctor Cañeque Rufo</cp:lastModifiedBy>
  <cp:revision>8</cp:revision>
  <dcterms:created xsi:type="dcterms:W3CDTF">2024-01-28T12:42:08Z</dcterms:created>
  <dcterms:modified xsi:type="dcterms:W3CDTF">2024-04-18T07:24:20Z</dcterms:modified>
</cp:coreProperties>
</file>